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1747257143" r:id="rId2"/>
    <p:sldId id="1747256986" r:id="rId3"/>
    <p:sldId id="1747257198" r:id="rId4"/>
    <p:sldId id="1747257151" r:id="rId5"/>
    <p:sldId id="1747257154" r:id="rId6"/>
    <p:sldId id="1747257155" r:id="rId7"/>
    <p:sldId id="1747257156" r:id="rId8"/>
    <p:sldId id="1747257167" r:id="rId9"/>
    <p:sldId id="1747257159" r:id="rId10"/>
    <p:sldId id="1747257196" r:id="rId11"/>
    <p:sldId id="1747257163" r:id="rId12"/>
    <p:sldId id="1747257162" r:id="rId13"/>
  </p:sldIdLst>
  <p:sldSz cx="12192000" cy="68580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25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45" autoAdjust="0"/>
    <p:restoredTop sz="95211" autoAdjust="0"/>
  </p:normalViewPr>
  <p:slideViewPr>
    <p:cSldViewPr snapToGrid="0" showGuides="1">
      <p:cViewPr varScale="1">
        <p:scale>
          <a:sx n="80" d="100"/>
          <a:sy n="80" d="100"/>
        </p:scale>
        <p:origin x="730" y="36"/>
      </p:cViewPr>
      <p:guideLst>
        <p:guide orient="horz" pos="624"/>
        <p:guide pos="25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738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FB79EA-C2A3-4435-8FFF-C2B0373EC42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46350" y="876300"/>
            <a:ext cx="42037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275" y="3373438"/>
            <a:ext cx="7435850" cy="27606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738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783352-CA05-4B2B-88B7-543B18211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0828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783352-CA05-4B2B-88B7-543B18211EAE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216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F6704-EBE4-2588-B729-3954CF93F8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A42C5D-7D73-0257-622D-BA8266D07B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9C88C0-9EC3-3465-8E4B-2B8A6FEE0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7E2B3E-145D-8976-6D67-933D7F445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010D5-82DF-75E5-5C17-F3F61A1BB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126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8DDF0-D18F-E731-FBC1-FFE6B3260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E43EF4-F025-7521-257D-9997451B35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96FF5B-8E06-5107-F9BA-AE6F4D175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C09C32-2C6A-48D7-F2B3-DE57C0A67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E45060-EBF4-51B6-F874-AD8E5C669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33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42CC11D-6D4B-C4F0-0FF6-E4D1D59423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BEA3F3-C68D-43ED-72C5-E739915BAA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1C27DC-B0EC-65C0-DDB3-7F4EDF111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2F5EB0-AE36-0F47-4B73-6BF62681B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F6F80C-8C20-DD25-4708-349501853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723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2311F-5F38-2209-4F91-252364B545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A6169D-F7AB-698A-AA04-06092FBA77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584CC0-CB08-CF95-B886-60584311B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CDCCD-5033-37B3-AA0E-D5783D351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3C709-BD4C-EEF0-39B8-A6D343488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410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89D86-069E-BE1D-CA71-EEF6D0613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63D67A-4945-36C8-19F8-28AF8B13E6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8523D2-6CA4-130B-E577-5908EC7C2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56FF0A-422D-01CD-B287-9E8E86242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F9F73-C470-FDF5-E1EA-DDF4A1D45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938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FE55F-6DF7-C24A-BE7C-94E646AE0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BCBC22-30FA-C327-1D5D-5BE7037EAC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28C84C-A705-7CE0-C114-7934C1A62B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A48EE9-B72E-9750-CE80-3EAC6D60C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470C04-2AA7-1CCF-CE2E-035BE3D1F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B2F226-0753-8D6E-8D49-DC1A06E6C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760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613C96-1D50-FEAF-B7F9-37896BF8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3A7D5-5DDC-B38C-B49A-8442CBEFF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EC02E0-63B1-2BC0-1D18-4F0B7DF28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AF6C7A-18DA-71EF-707F-1D1B1C8AED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89BF34-C15C-3EBF-C96A-6072555A37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72608D-F9C1-42BD-F2A8-9CAAFBC9D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89805F-E2F3-F791-4C48-71B22C1F1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C36EB1-D5D6-2244-52A7-B0506C93F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744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55368-80A8-A0A3-2C2C-A8B9ED0967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6C1779-4CD6-BBEA-ABF6-6DAE937F2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674998-A8E7-504A-A2EA-2F8EE1016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79B6F1-84E4-9E0C-044A-018FA6C05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43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BF5D15-E5B9-A7A6-6E1C-50240A3AA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F83B4A-6887-CD49-7086-49C562014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315DEF-B36C-A172-9AA1-056525F97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333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A83E6-9BC0-623F-7F40-B3446E44B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E45CB5-E402-7778-2707-C36761510D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4B3EE7-9C8E-1E13-0A2E-A52E48071E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20D770-0768-D641-22FF-588F06212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6C961-847A-1644-9B61-1362ECE2F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AF3158-0525-5A1D-9104-4D2050844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377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89B97-3D3E-21AF-207A-B8FF1FEC6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468CB6-E86C-3CFC-04B7-62BB3C8EC0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18B8A0-8BD0-141C-BC75-BFEAA1721E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7CC4A5-80E9-F9E6-7D18-31BD2BA74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1E92E0-CE95-E142-1899-1A9D2E2ED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239A10-2DA7-E37C-F338-EBB9732E6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5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A31E73-3F75-2F13-30BE-B60ECB8FF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DD6176-1FD3-FD31-A0E7-0421EEDA81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54E50-52FB-467D-CD3A-F9653B65C4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64540-1615-4E21-AD4E-B9AA295AE819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E9E90-6594-0F7C-24FD-2935F9ACE4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DAFCE-80F9-BDF0-25BB-7DB2FDE8C4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79917-C2F9-4061-A255-A196819D8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90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8.bin"/><Relationship Id="rId13" Type="http://schemas.openxmlformats.org/officeDocument/2006/relationships/image" Target="../media/image44.emf"/><Relationship Id="rId18" Type="http://schemas.openxmlformats.org/officeDocument/2006/relationships/oleObject" Target="../embeddings/oleObject43.bin"/><Relationship Id="rId3" Type="http://schemas.openxmlformats.org/officeDocument/2006/relationships/image" Target="../media/image39.emf"/><Relationship Id="rId7" Type="http://schemas.openxmlformats.org/officeDocument/2006/relationships/image" Target="../media/image41.emf"/><Relationship Id="rId12" Type="http://schemas.openxmlformats.org/officeDocument/2006/relationships/oleObject" Target="../embeddings/oleObject40.bin"/><Relationship Id="rId17" Type="http://schemas.openxmlformats.org/officeDocument/2006/relationships/image" Target="../media/image46.emf"/><Relationship Id="rId2" Type="http://schemas.openxmlformats.org/officeDocument/2006/relationships/oleObject" Target="../embeddings/oleObject35.bin"/><Relationship Id="rId16" Type="http://schemas.openxmlformats.org/officeDocument/2006/relationships/oleObject" Target="../embeddings/oleObject4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7.bin"/><Relationship Id="rId11" Type="http://schemas.openxmlformats.org/officeDocument/2006/relationships/image" Target="../media/image43.emf"/><Relationship Id="rId5" Type="http://schemas.openxmlformats.org/officeDocument/2006/relationships/image" Target="../media/image40.emf"/><Relationship Id="rId15" Type="http://schemas.openxmlformats.org/officeDocument/2006/relationships/image" Target="../media/image45.emf"/><Relationship Id="rId10" Type="http://schemas.openxmlformats.org/officeDocument/2006/relationships/oleObject" Target="../embeddings/oleObject39.bin"/><Relationship Id="rId19" Type="http://schemas.openxmlformats.org/officeDocument/2006/relationships/image" Target="../media/image47.emf"/><Relationship Id="rId4" Type="http://schemas.openxmlformats.org/officeDocument/2006/relationships/oleObject" Target="../embeddings/oleObject36.bin"/><Relationship Id="rId9" Type="http://schemas.openxmlformats.org/officeDocument/2006/relationships/image" Target="../media/image42.emf"/><Relationship Id="rId14" Type="http://schemas.openxmlformats.org/officeDocument/2006/relationships/oleObject" Target="../embeddings/oleObject41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13" Type="http://schemas.openxmlformats.org/officeDocument/2006/relationships/image" Target="../media/image53.emf"/><Relationship Id="rId3" Type="http://schemas.openxmlformats.org/officeDocument/2006/relationships/oleObject" Target="../embeddings/oleObject44.bin"/><Relationship Id="rId7" Type="http://schemas.openxmlformats.org/officeDocument/2006/relationships/oleObject" Target="../embeddings/oleObject46.bin"/><Relationship Id="rId12" Type="http://schemas.openxmlformats.org/officeDocument/2006/relationships/oleObject" Target="../embeddings/oleObject48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emf"/><Relationship Id="rId11" Type="http://schemas.openxmlformats.org/officeDocument/2006/relationships/image" Target="../media/image52.png"/><Relationship Id="rId5" Type="http://schemas.openxmlformats.org/officeDocument/2006/relationships/oleObject" Target="../embeddings/oleObject45.bin"/><Relationship Id="rId15" Type="http://schemas.openxmlformats.org/officeDocument/2006/relationships/image" Target="../media/image54.emf"/><Relationship Id="rId10" Type="http://schemas.openxmlformats.org/officeDocument/2006/relationships/image" Target="../media/image51.emf"/><Relationship Id="rId4" Type="http://schemas.openxmlformats.org/officeDocument/2006/relationships/image" Target="../media/image48.emf"/><Relationship Id="rId9" Type="http://schemas.openxmlformats.org/officeDocument/2006/relationships/oleObject" Target="../embeddings/oleObject47.bin"/><Relationship Id="rId14" Type="http://schemas.openxmlformats.org/officeDocument/2006/relationships/oleObject" Target="../embeddings/oleObject49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3.bin"/><Relationship Id="rId3" Type="http://schemas.openxmlformats.org/officeDocument/2006/relationships/image" Target="../media/image55.emf"/><Relationship Id="rId7" Type="http://schemas.openxmlformats.org/officeDocument/2006/relationships/image" Target="../media/image57.emf"/><Relationship Id="rId2" Type="http://schemas.openxmlformats.org/officeDocument/2006/relationships/oleObject" Target="../embeddings/oleObject5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2.bin"/><Relationship Id="rId5" Type="http://schemas.openxmlformats.org/officeDocument/2006/relationships/image" Target="../media/image56.emf"/><Relationship Id="rId4" Type="http://schemas.openxmlformats.org/officeDocument/2006/relationships/oleObject" Target="../embeddings/oleObject51.bin"/><Relationship Id="rId9" Type="http://schemas.openxmlformats.org/officeDocument/2006/relationships/image" Target="../media/image5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10.emf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image" Target="../media/image15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5.bin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4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3" Type="http://schemas.openxmlformats.org/officeDocument/2006/relationships/image" Target="../media/image19.emf"/><Relationship Id="rId7" Type="http://schemas.openxmlformats.org/officeDocument/2006/relationships/image" Target="../media/image21.emf"/><Relationship Id="rId2" Type="http://schemas.openxmlformats.org/officeDocument/2006/relationships/oleObject" Target="../embeddings/oleObject1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0.bin"/><Relationship Id="rId5" Type="http://schemas.openxmlformats.org/officeDocument/2006/relationships/image" Target="../media/image20.emf"/><Relationship Id="rId4" Type="http://schemas.openxmlformats.org/officeDocument/2006/relationships/oleObject" Target="../embeddings/oleObject19.bin"/><Relationship Id="rId9" Type="http://schemas.openxmlformats.org/officeDocument/2006/relationships/image" Target="../media/image2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5.bin"/><Relationship Id="rId3" Type="http://schemas.openxmlformats.org/officeDocument/2006/relationships/image" Target="../media/image26.emf"/><Relationship Id="rId7" Type="http://schemas.openxmlformats.org/officeDocument/2006/relationships/image" Target="../media/image28.e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4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0" Type="http://schemas.openxmlformats.org/officeDocument/2006/relationships/oleObject" Target="../embeddings/oleObject26.bin"/><Relationship Id="rId4" Type="http://schemas.openxmlformats.org/officeDocument/2006/relationships/oleObject" Target="../embeddings/oleObject23.bin"/><Relationship Id="rId9" Type="http://schemas.openxmlformats.org/officeDocument/2006/relationships/image" Target="../media/image29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0.bin"/><Relationship Id="rId3" Type="http://schemas.openxmlformats.org/officeDocument/2006/relationships/image" Target="../media/image31.emf"/><Relationship Id="rId7" Type="http://schemas.openxmlformats.org/officeDocument/2006/relationships/image" Target="../media/image33.emf"/><Relationship Id="rId2" Type="http://schemas.openxmlformats.org/officeDocument/2006/relationships/oleObject" Target="../embeddings/oleObject27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9.bin"/><Relationship Id="rId5" Type="http://schemas.openxmlformats.org/officeDocument/2006/relationships/image" Target="../media/image32.emf"/><Relationship Id="rId4" Type="http://schemas.openxmlformats.org/officeDocument/2006/relationships/oleObject" Target="../embeddings/oleObject28.bin"/><Relationship Id="rId9" Type="http://schemas.openxmlformats.org/officeDocument/2006/relationships/image" Target="../media/image34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4.bin"/><Relationship Id="rId3" Type="http://schemas.openxmlformats.org/officeDocument/2006/relationships/image" Target="../media/image35.emf"/><Relationship Id="rId7" Type="http://schemas.openxmlformats.org/officeDocument/2006/relationships/image" Target="../media/image37.emf"/><Relationship Id="rId2" Type="http://schemas.openxmlformats.org/officeDocument/2006/relationships/oleObject" Target="../embeddings/oleObject3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3.bin"/><Relationship Id="rId5" Type="http://schemas.openxmlformats.org/officeDocument/2006/relationships/image" Target="../media/image36.emf"/><Relationship Id="rId4" Type="http://schemas.openxmlformats.org/officeDocument/2006/relationships/oleObject" Target="../embeddings/oleObject32.bin"/><Relationship Id="rId9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0762D60-C4D9-4832-A6F9-C04458FD45FC}"/>
              </a:ext>
            </a:extLst>
          </p:cNvPr>
          <p:cNvGrpSpPr/>
          <p:nvPr/>
        </p:nvGrpSpPr>
        <p:grpSpPr>
          <a:xfrm>
            <a:off x="524855" y="745706"/>
            <a:ext cx="5440732" cy="4605269"/>
            <a:chOff x="4343052" y="358426"/>
            <a:chExt cx="5440732" cy="4605269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E4E81DEE-CAEF-4676-BD5F-B7EC1BA082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9993657"/>
                </p:ext>
              </p:extLst>
            </p:nvPr>
          </p:nvGraphicFramePr>
          <p:xfrm>
            <a:off x="4356280" y="382017"/>
            <a:ext cx="2902167" cy="1947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4464873" imgH="2995961" progId="Prism9.Document">
                    <p:embed/>
                  </p:oleObj>
                </mc:Choice>
                <mc:Fallback>
                  <p:oleObj name="Prism 9" r:id="rId2" imgW="4464873" imgH="2995961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E4E81DEE-CAEF-4676-BD5F-B7EC1BA082E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356280" y="382017"/>
                          <a:ext cx="2902167" cy="1947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C575E640-EC8C-4501-8BF9-98E9277D187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21913277"/>
                </p:ext>
              </p:extLst>
            </p:nvPr>
          </p:nvGraphicFramePr>
          <p:xfrm>
            <a:off x="7474217" y="384245"/>
            <a:ext cx="2307883" cy="19424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550589" imgH="2988401" progId="Prism9.Document">
                    <p:embed/>
                  </p:oleObj>
                </mc:Choice>
                <mc:Fallback>
                  <p:oleObj name="Prism 9" r:id="rId4" imgW="3550589" imgH="2988401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C575E640-EC8C-4501-8BF9-98E9277D187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7474217" y="384245"/>
                          <a:ext cx="2307883" cy="19424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11E8A6EB-985B-4BC7-857C-346004FFDD6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8526560"/>
                </p:ext>
              </p:extLst>
            </p:nvPr>
          </p:nvGraphicFramePr>
          <p:xfrm>
            <a:off x="4343052" y="3012175"/>
            <a:ext cx="2931882" cy="1947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4510587" imgH="2995961" progId="Prism9.Document">
                    <p:embed/>
                  </p:oleObj>
                </mc:Choice>
                <mc:Fallback>
                  <p:oleObj name="Prism 9" r:id="rId6" imgW="4510587" imgH="2995961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11E8A6EB-985B-4BC7-857C-346004FFDD6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343052" y="3012175"/>
                          <a:ext cx="2931882" cy="1947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58478F67-E8B6-4C6B-A899-3D5C5DFA698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89677950"/>
                </p:ext>
              </p:extLst>
            </p:nvPr>
          </p:nvGraphicFramePr>
          <p:xfrm>
            <a:off x="7451100" y="3021234"/>
            <a:ext cx="2332684" cy="19424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3588744" imgH="2988401" progId="Prism9.Document">
                    <p:embed/>
                  </p:oleObj>
                </mc:Choice>
                <mc:Fallback>
                  <p:oleObj name="Prism 9" r:id="rId8" imgW="3588744" imgH="2988401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58478F67-E8B6-4C6B-A899-3D5C5DFA698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451100" y="3021234"/>
                          <a:ext cx="2332684" cy="19424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30E122C-BA9A-4FDF-A738-2EDC765D3297}"/>
                </a:ext>
              </a:extLst>
            </p:cNvPr>
            <p:cNvSpPr txBox="1"/>
            <p:nvPr/>
          </p:nvSpPr>
          <p:spPr>
            <a:xfrm>
              <a:off x="4397746" y="358426"/>
              <a:ext cx="3355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                                                     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0EC326F-BDD7-45FA-AC12-0AE61A9A2036}"/>
                </a:ext>
              </a:extLst>
            </p:cNvPr>
            <p:cNvSpPr txBox="1"/>
            <p:nvPr/>
          </p:nvSpPr>
          <p:spPr>
            <a:xfrm>
              <a:off x="4465986" y="2974096"/>
              <a:ext cx="3316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                                                     D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6C8088D7-450C-4C91-9CFC-D6F98E686E92}"/>
              </a:ext>
            </a:extLst>
          </p:cNvPr>
          <p:cNvSpPr txBox="1"/>
          <p:nvPr/>
        </p:nvSpPr>
        <p:spPr>
          <a:xfrm>
            <a:off x="-25264" y="-6850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E86604-44A4-4F87-B101-8883E091C303}"/>
              </a:ext>
            </a:extLst>
          </p:cNvPr>
          <p:cNvSpPr txBox="1"/>
          <p:nvPr/>
        </p:nvSpPr>
        <p:spPr>
          <a:xfrm>
            <a:off x="589487" y="5553057"/>
            <a:ext cx="108149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. </a:t>
            </a:r>
            <a:r>
              <a:rPr lang="en-US" sz="1200" dirty="0"/>
              <a:t>Effect of the combination of YIV-906’s components herbs: Glycyrrhiza uralensis Fisch (G), Paeonia lactiflora Pall (P), Scutellaria baicalensis Georgi (S), and Ziziphus jujuba Mill (Z) on NFAT mediated transcriptional activity of Jurkat-PD1 cells which were incubated with Raji cells without SEE (</a:t>
            </a:r>
            <a:r>
              <a:rPr lang="en-US" sz="1200" b="1" dirty="0"/>
              <a:t>A, C</a:t>
            </a:r>
            <a:r>
              <a:rPr lang="en-US" sz="1200" dirty="0"/>
              <a:t>) and with SEE (</a:t>
            </a:r>
            <a:r>
              <a:rPr lang="en-US" sz="1200" b="1" dirty="0"/>
              <a:t>B, D</a:t>
            </a:r>
            <a:r>
              <a:rPr lang="en-US" sz="1200" dirty="0"/>
              <a:t>) and Jurkat-PD1 cells which were incubated with Raji-PD-L1 cells without SEE (</a:t>
            </a:r>
            <a:r>
              <a:rPr lang="en-US" sz="1200" b="1" dirty="0"/>
              <a:t>E, G</a:t>
            </a:r>
            <a:r>
              <a:rPr lang="en-US" sz="1200" dirty="0"/>
              <a:t>) and with SEE (</a:t>
            </a:r>
            <a:r>
              <a:rPr lang="en-US" sz="1200" b="1" dirty="0"/>
              <a:t>F, H</a:t>
            </a:r>
            <a:r>
              <a:rPr lang="en-US" sz="1200" dirty="0"/>
              <a:t>) were compared. Details of experimental procedures are given in Materials and Methods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41DD18E-16D9-958D-2579-FB8E8EAD500C}"/>
              </a:ext>
            </a:extLst>
          </p:cNvPr>
          <p:cNvGrpSpPr/>
          <p:nvPr/>
        </p:nvGrpSpPr>
        <p:grpSpPr>
          <a:xfrm>
            <a:off x="6096000" y="745706"/>
            <a:ext cx="5333233" cy="4598630"/>
            <a:chOff x="4160996" y="1079518"/>
            <a:chExt cx="5333233" cy="459863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3FF2026-D412-5AB9-F486-6B3052C23BC2}"/>
                </a:ext>
              </a:extLst>
            </p:cNvPr>
            <p:cNvSpPr txBox="1"/>
            <p:nvPr/>
          </p:nvSpPr>
          <p:spPr>
            <a:xfrm>
              <a:off x="4193880" y="1079518"/>
              <a:ext cx="3195105" cy="30162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E                                                    G</a:t>
              </a:r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sz="2800" b="1" dirty="0"/>
            </a:p>
            <a:p>
              <a:r>
                <a:rPr lang="en-US" b="1" dirty="0"/>
                <a:t>F                                                    H</a:t>
              </a:r>
            </a:p>
          </p:txBody>
        </p:sp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06A0B506-287C-7FB9-5858-50C10E54457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40055480"/>
                </p:ext>
              </p:extLst>
            </p:nvPr>
          </p:nvGraphicFramePr>
          <p:xfrm>
            <a:off x="4160996" y="3730773"/>
            <a:ext cx="2931882" cy="1947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4510587" imgH="2995961" progId="Prism9.Document">
                    <p:embed/>
                  </p:oleObj>
                </mc:Choice>
                <mc:Fallback>
                  <p:oleObj name="Prism 9" r:id="rId10" imgW="4510587" imgH="2995961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7C085806-72F8-4643-85B5-476711411D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160996" y="3730773"/>
                          <a:ext cx="2931882" cy="1947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21241DD7-AA22-A5F9-41E7-74FEE94CD1A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01241886"/>
                </p:ext>
              </p:extLst>
            </p:nvPr>
          </p:nvGraphicFramePr>
          <p:xfrm>
            <a:off x="4193888" y="1131343"/>
            <a:ext cx="2902167" cy="1947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4464873" imgH="2995961" progId="Prism9.Document">
                    <p:embed/>
                  </p:oleObj>
                </mc:Choice>
                <mc:Fallback>
                  <p:oleObj name="Prism 9" r:id="rId12" imgW="4464873" imgH="2995961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D92A60A2-C52B-452A-B764-50E6765C7E2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193888" y="1131343"/>
                          <a:ext cx="2902167" cy="1947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61918E02-4A8A-1E30-37B5-E88872834B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1578797"/>
                </p:ext>
              </p:extLst>
            </p:nvPr>
          </p:nvGraphicFramePr>
          <p:xfrm>
            <a:off x="7161545" y="1120335"/>
            <a:ext cx="2307883" cy="19424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3550589" imgH="2988401" progId="Prism9.Document">
                    <p:embed/>
                  </p:oleObj>
                </mc:Choice>
                <mc:Fallback>
                  <p:oleObj name="Prism 9" r:id="rId14" imgW="3550589" imgH="2988401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878E103D-ED7F-4DE3-ACB5-7E7ED3BC63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7161545" y="1120335"/>
                          <a:ext cx="2307883" cy="19424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6216B352-0C6F-8016-7ED7-66B32480F6E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3889807"/>
                </p:ext>
              </p:extLst>
            </p:nvPr>
          </p:nvGraphicFramePr>
          <p:xfrm>
            <a:off x="7161545" y="3735611"/>
            <a:ext cx="2332684" cy="19424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6" imgW="3588744" imgH="2988401" progId="Prism9.Document">
                    <p:embed/>
                  </p:oleObj>
                </mc:Choice>
                <mc:Fallback>
                  <p:oleObj name="Prism 9" r:id="rId16" imgW="3588744" imgH="2988401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EE5B7593-30A0-46E1-9C83-277DCBA6A0B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7161545" y="3735611"/>
                          <a:ext cx="2332684" cy="19424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1987082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15801A7-EEF0-BDB4-FF46-A584A95FD9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6659024"/>
              </p:ext>
            </p:extLst>
          </p:nvPr>
        </p:nvGraphicFramePr>
        <p:xfrm>
          <a:off x="2059631" y="352886"/>
          <a:ext cx="2660566" cy="1813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34277" imgH="3023318" progId="Prism9.Document">
                  <p:embed/>
                </p:oleObj>
              </mc:Choice>
              <mc:Fallback>
                <p:oleObj name="Prism 9" r:id="rId2" imgW="4434277" imgH="3023318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15801A7-EEF0-BDB4-FF46-A584A95FD9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59631" y="352886"/>
                        <a:ext cx="2660566" cy="1813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56F0DBC-69AA-DE95-D1FF-D7D6CCE53D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2269675"/>
              </p:ext>
            </p:extLst>
          </p:nvPr>
        </p:nvGraphicFramePr>
        <p:xfrm>
          <a:off x="4834013" y="354475"/>
          <a:ext cx="2660566" cy="1813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34277" imgH="3023318" progId="Prism9.Document">
                  <p:embed/>
                </p:oleObj>
              </mc:Choice>
              <mc:Fallback>
                <p:oleObj name="Prism 9" r:id="rId4" imgW="4434277" imgH="3023318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56F0DBC-69AA-DE95-D1FF-D7D6CCE53D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34013" y="354475"/>
                        <a:ext cx="2660566" cy="1813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9A3D6C2-8422-C30C-5A7B-05EA4E0B7A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479423"/>
              </p:ext>
            </p:extLst>
          </p:nvPr>
        </p:nvGraphicFramePr>
        <p:xfrm>
          <a:off x="7543870" y="370350"/>
          <a:ext cx="2651495" cy="17865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419159" imgH="2977602" progId="Prism9.Document">
                  <p:embed/>
                </p:oleObj>
              </mc:Choice>
              <mc:Fallback>
                <p:oleObj name="Prism 9" r:id="rId6" imgW="4419159" imgH="297760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9A3D6C2-8422-C30C-5A7B-05EA4E0B7A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543870" y="370350"/>
                        <a:ext cx="2651495" cy="17865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24CCA3B-5000-EBE2-0683-6DCD238430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6865869"/>
              </p:ext>
            </p:extLst>
          </p:nvPr>
        </p:nvGraphicFramePr>
        <p:xfrm>
          <a:off x="2111948" y="2097097"/>
          <a:ext cx="2610244" cy="1813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350407" imgH="3023318" progId="Prism9.Document">
                  <p:embed/>
                </p:oleObj>
              </mc:Choice>
              <mc:Fallback>
                <p:oleObj name="Prism 9" r:id="rId8" imgW="4350407" imgH="3023318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5C7EEF73-C07D-C751-D8AC-6E95408226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111948" y="2097097"/>
                        <a:ext cx="2610244" cy="1813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AF72CCC-6CEE-CF1D-5F68-666EE90982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8004914"/>
              </p:ext>
            </p:extLst>
          </p:nvPr>
        </p:nvGraphicFramePr>
        <p:xfrm>
          <a:off x="4894338" y="2100271"/>
          <a:ext cx="2610244" cy="18094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350407" imgH="3015758" progId="Prism9.Document">
                  <p:embed/>
                </p:oleObj>
              </mc:Choice>
              <mc:Fallback>
                <p:oleObj name="Prism 9" r:id="rId10" imgW="4350407" imgH="3015758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4715216-3AF6-20AE-A2DC-404CE5B1DC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894338" y="2100271"/>
                        <a:ext cx="2610244" cy="18094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5094FA8E-4DFF-4F20-74B7-7A09B36DC8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2846441"/>
              </p:ext>
            </p:extLst>
          </p:nvPr>
        </p:nvGraphicFramePr>
        <p:xfrm>
          <a:off x="7594293" y="2100281"/>
          <a:ext cx="2610244" cy="1825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350407" imgH="3041676" progId="Prism9.Document">
                  <p:embed/>
                </p:oleObj>
              </mc:Choice>
              <mc:Fallback>
                <p:oleObj name="Prism 9" r:id="rId12" imgW="4350407" imgH="3041676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5210D7E-4699-4791-AB45-BE02EF7FA7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594293" y="2100281"/>
                        <a:ext cx="2610244" cy="1825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1AC94F83-550B-7C45-8684-5F36F1FFCE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1852009"/>
              </p:ext>
            </p:extLst>
          </p:nvPr>
        </p:nvGraphicFramePr>
        <p:xfrm>
          <a:off x="2054227" y="3846075"/>
          <a:ext cx="2660566" cy="1813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434277" imgH="3023318" progId="Prism9.Document">
                  <p:embed/>
                </p:oleObj>
              </mc:Choice>
              <mc:Fallback>
                <p:oleObj name="Prism 9" r:id="rId14" imgW="4434277" imgH="3023318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3266235-3D72-5420-87C2-772967A0B6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054227" y="3846075"/>
                        <a:ext cx="2660566" cy="1813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DE7C7814-C46F-B42A-9239-87C82E9B5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3231131"/>
              </p:ext>
            </p:extLst>
          </p:nvPr>
        </p:nvGraphicFramePr>
        <p:xfrm>
          <a:off x="4839919" y="3848494"/>
          <a:ext cx="2660566" cy="18094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4434277" imgH="3015758" progId="Prism9.Document">
                  <p:embed/>
                </p:oleObj>
              </mc:Choice>
              <mc:Fallback>
                <p:oleObj name="Prism 9" r:id="rId16" imgW="4434277" imgH="3015758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87CC23F-44CA-1EFF-5109-4DBD426360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839919" y="3848494"/>
                        <a:ext cx="2660566" cy="18094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8559C8B4-BB7F-4D36-B562-C9FA978478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8641914"/>
              </p:ext>
            </p:extLst>
          </p:nvPr>
        </p:nvGraphicFramePr>
        <p:xfrm>
          <a:off x="7548204" y="3839629"/>
          <a:ext cx="2651495" cy="1777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4419159" imgH="2962484" progId="Prism9.Document">
                  <p:embed/>
                </p:oleObj>
              </mc:Choice>
              <mc:Fallback>
                <p:oleObj name="Prism 9" r:id="rId18" imgW="4419159" imgH="2962484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3561758-950C-85BE-A911-FFCA56B57C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548204" y="3839629"/>
                        <a:ext cx="2651495" cy="1777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6442C35C-8464-3836-FA59-FBBCA22EE647}"/>
              </a:ext>
            </a:extLst>
          </p:cNvPr>
          <p:cNvSpPr txBox="1"/>
          <p:nvPr/>
        </p:nvSpPr>
        <p:spPr>
          <a:xfrm>
            <a:off x="-45556" y="-8199"/>
            <a:ext cx="258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0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B4DD623-1209-1D2B-7A9C-A68C10FC5005}"/>
              </a:ext>
            </a:extLst>
          </p:cNvPr>
          <p:cNvSpPr txBox="1"/>
          <p:nvPr/>
        </p:nvSpPr>
        <p:spPr>
          <a:xfrm>
            <a:off x="1981312" y="433703"/>
            <a:ext cx="613701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                                                  B                                                   C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D                                                   E                                                   F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G                                                   H                                                   I                                                        </a:t>
            </a:r>
          </a:p>
          <a:p>
            <a:endParaRPr lang="en-US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E04B56-633C-CBE0-6274-7FCD8342726C}"/>
              </a:ext>
            </a:extLst>
          </p:cNvPr>
          <p:cNvSpPr txBox="1"/>
          <p:nvPr/>
        </p:nvSpPr>
        <p:spPr>
          <a:xfrm>
            <a:off x="227390" y="5649074"/>
            <a:ext cx="117372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10</a:t>
            </a:r>
            <a:r>
              <a:rPr lang="en-US" sz="1200" dirty="0"/>
              <a:t>. Effects of YIV-906 or </a:t>
            </a:r>
            <a:r>
              <a:rPr lang="en-US" sz="1200" b="1" dirty="0"/>
              <a:t>S</a:t>
            </a:r>
            <a:r>
              <a:rPr lang="en-US" sz="1200" dirty="0"/>
              <a:t> on IL2 (</a:t>
            </a:r>
            <a:r>
              <a:rPr lang="en-US" sz="1200" b="1" dirty="0"/>
              <a:t>A to C</a:t>
            </a:r>
            <a:r>
              <a:rPr lang="en-US" sz="1200" dirty="0"/>
              <a:t>), IFNg (</a:t>
            </a:r>
            <a:r>
              <a:rPr lang="en-US" sz="1200" b="1" dirty="0"/>
              <a:t>D to F</a:t>
            </a:r>
            <a:r>
              <a:rPr lang="en-US" sz="1200" dirty="0"/>
              <a:t>) and IL10 (</a:t>
            </a:r>
            <a:r>
              <a:rPr lang="en-US" sz="1200" b="1" dirty="0"/>
              <a:t>G to I</a:t>
            </a:r>
            <a:r>
              <a:rPr lang="en-US" sz="1200" dirty="0"/>
              <a:t>) of medium cultured with Jurkat+PD1+Raji, Jurkat+Raji-PDL1, Jurkat-PD1-CAR-CD19, Jurkat-PD1, Raji or Raji-PD-L1 cells as indicated in the graphs. YIV-906 or </a:t>
            </a:r>
            <a:r>
              <a:rPr lang="en-US" sz="1200" b="1" dirty="0"/>
              <a:t>S</a:t>
            </a:r>
            <a:r>
              <a:rPr lang="en-US" sz="1200" dirty="0"/>
              <a:t> were added to with Jurkat+PD1+Raji, Jurkat+Raji-PDL1, Jurkat-PD1-CAR-CD19, Jurkat-PD1, Raji or Raji-PD-L1 cells for 24 h. IL2, IFNg and IL10 of culture medium were determined using bead array assays. Details of experimental procedures are given in Materials and Methods.</a:t>
            </a:r>
          </a:p>
        </p:txBody>
      </p:sp>
    </p:spTree>
    <p:extLst>
      <p:ext uri="{BB962C8B-B14F-4D97-AF65-F5344CB8AC3E}">
        <p14:creationId xmlns:p14="http://schemas.microsoft.com/office/powerpoint/2010/main" val="3563882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78CE6DE7-291A-3A2F-9C6E-963A6EA9421C}"/>
              </a:ext>
            </a:extLst>
          </p:cNvPr>
          <p:cNvSpPr txBox="1"/>
          <p:nvPr/>
        </p:nvSpPr>
        <p:spPr>
          <a:xfrm>
            <a:off x="125790" y="41410"/>
            <a:ext cx="2535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1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0F96608-9B77-3305-F745-2B9893714C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5107795"/>
              </p:ext>
            </p:extLst>
          </p:nvPr>
        </p:nvGraphicFramePr>
        <p:xfrm>
          <a:off x="1009804" y="412885"/>
          <a:ext cx="3226360" cy="2637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795718" imgH="3102509" progId="Prism9.Document">
                  <p:embed/>
                </p:oleObj>
              </mc:Choice>
              <mc:Fallback>
                <p:oleObj name="Prism 9" r:id="rId3" imgW="3795718" imgH="3102509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D0F96608-9B77-3305-F745-2B9893714C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09804" y="412885"/>
                        <a:ext cx="3226360" cy="26371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6B639B0C-1AB3-4426-6367-F843166FC8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2887914"/>
              </p:ext>
            </p:extLst>
          </p:nvPr>
        </p:nvGraphicFramePr>
        <p:xfrm>
          <a:off x="1009804" y="3043892"/>
          <a:ext cx="3226360" cy="26371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795718" imgH="3102509" progId="Prism9.Document">
                  <p:embed/>
                </p:oleObj>
              </mc:Choice>
              <mc:Fallback>
                <p:oleObj name="Prism 9" r:id="rId5" imgW="3795718" imgH="3102509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6B639B0C-1AB3-4426-6367-F843166FC8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9804" y="3043892"/>
                        <a:ext cx="3226360" cy="26371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CD930263-65E6-AE3C-D726-9FD0BF5876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1595285"/>
              </p:ext>
            </p:extLst>
          </p:nvPr>
        </p:nvGraphicFramePr>
        <p:xfrm>
          <a:off x="4126277" y="661607"/>
          <a:ext cx="2581682" cy="2552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442243" imgH="3402717" progId="Prism9.Document">
                  <p:embed/>
                </p:oleObj>
              </mc:Choice>
              <mc:Fallback>
                <p:oleObj name="Prism 9" r:id="rId7" imgW="3442243" imgH="3402717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CD930263-65E6-AE3C-D726-9FD0BF5876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26277" y="661607"/>
                        <a:ext cx="2581682" cy="2552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6671EDFC-E8B3-C4E3-77B8-FDD2336C3C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208282"/>
              </p:ext>
            </p:extLst>
          </p:nvPr>
        </p:nvGraphicFramePr>
        <p:xfrm>
          <a:off x="4122228" y="3287086"/>
          <a:ext cx="2589781" cy="2552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453041" imgH="3402717" progId="Prism9.Document">
                  <p:embed/>
                </p:oleObj>
              </mc:Choice>
              <mc:Fallback>
                <p:oleObj name="Prism 9" r:id="rId9" imgW="3453041" imgH="3402717" progId="Prism9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6671EDFC-E8B3-C4E3-77B8-FDD2336C3C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122228" y="3287086"/>
                        <a:ext cx="2589781" cy="2552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2167011-0B6F-7E53-D817-F071FCE1E968}"/>
              </a:ext>
            </a:extLst>
          </p:cNvPr>
          <p:cNvSpPr txBox="1"/>
          <p:nvPr/>
        </p:nvSpPr>
        <p:spPr>
          <a:xfrm>
            <a:off x="806324" y="5805354"/>
            <a:ext cx="1085348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1. </a:t>
            </a:r>
            <a:r>
              <a:rPr lang="en-US" sz="1200" dirty="0"/>
              <a:t>Effect of YIV-906 and its component herbs on cell death of Raji or K562 cells induced by Jurkat-PD1-CAR-CD19 (CAR). Effect of YIV-906 on cell death of Raji (</a:t>
            </a:r>
            <a:r>
              <a:rPr lang="en-US" sz="1200" b="1" dirty="0"/>
              <a:t>A</a:t>
            </a:r>
            <a:r>
              <a:rPr lang="en-US" sz="1200" dirty="0"/>
              <a:t>) and Raji-PD-L1 (</a:t>
            </a:r>
            <a:r>
              <a:rPr lang="en-US" sz="1200" b="1" dirty="0"/>
              <a:t>B</a:t>
            </a:r>
            <a:r>
              <a:rPr lang="en-US" sz="1200" dirty="0"/>
              <a:t>) induced by Jurkat-PD1-CAR-CD19 cells. Effect of YIV-906 component herbs: G, P, S, Z on cell death of Raji (</a:t>
            </a:r>
            <a:r>
              <a:rPr lang="en-US" sz="1200" b="1" dirty="0"/>
              <a:t>C</a:t>
            </a:r>
            <a:r>
              <a:rPr lang="en-US" sz="1200" dirty="0"/>
              <a:t>) and Raji-PD-L1 (</a:t>
            </a:r>
            <a:r>
              <a:rPr lang="en-US" sz="1200" b="1" dirty="0"/>
              <a:t>D</a:t>
            </a:r>
            <a:r>
              <a:rPr lang="en-US" sz="1200" dirty="0"/>
              <a:t>) induced by Jurkat-PD1-CAR-CD19 cells. (</a:t>
            </a:r>
            <a:r>
              <a:rPr lang="en-US" sz="1200" b="1" dirty="0"/>
              <a:t>E)</a:t>
            </a:r>
            <a:r>
              <a:rPr lang="en-US" sz="1200" dirty="0"/>
              <a:t> Expression of CD19 on Raji cells and K562 cells. (</a:t>
            </a:r>
            <a:r>
              <a:rPr lang="en-US" sz="1200" b="1" dirty="0"/>
              <a:t>F</a:t>
            </a:r>
            <a:r>
              <a:rPr lang="en-US" sz="1200" dirty="0"/>
              <a:t>) Effect of YIV-906 and S on NFAT activity of Jurkat-PD1-CAR-CD19 cells when co-culturing with Raji and K562 cells. (</a:t>
            </a:r>
            <a:r>
              <a:rPr lang="en-US" sz="1200" b="1" dirty="0"/>
              <a:t>G</a:t>
            </a:r>
            <a:r>
              <a:rPr lang="en-US" sz="1200" dirty="0"/>
              <a:t>) Effect of YIV-906 and S on cell death of Raji and K562 cells when co-culturing with  Jurkat-PD1-CAR-CD19 cells. Details of experimental procedures are given in Materials and Methods.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8B4E296-6B48-3B53-A252-3C89DD437062}"/>
              </a:ext>
            </a:extLst>
          </p:cNvPr>
          <p:cNvGrpSpPr/>
          <p:nvPr/>
        </p:nvGrpSpPr>
        <p:grpSpPr>
          <a:xfrm>
            <a:off x="7396179" y="475295"/>
            <a:ext cx="2965744" cy="1543447"/>
            <a:chOff x="7352637" y="581731"/>
            <a:chExt cx="2965744" cy="1543447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6ECD3E1-957B-D016-3E8B-0F58E1D755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5100" b="9959"/>
            <a:stretch/>
          </p:blipFill>
          <p:spPr>
            <a:xfrm>
              <a:off x="7384380" y="745676"/>
              <a:ext cx="2934001" cy="137950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E9C0327-9EDA-CA9C-2C9A-F1F652A88547}"/>
                </a:ext>
              </a:extLst>
            </p:cNvPr>
            <p:cNvSpPr txBox="1"/>
            <p:nvPr/>
          </p:nvSpPr>
          <p:spPr>
            <a:xfrm>
              <a:off x="7628839" y="616158"/>
              <a:ext cx="92653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400" dirty="0"/>
                <a:t>    Raji  cells    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DA26862-FCF2-1DDF-36A0-82A4C097B9C5}"/>
                </a:ext>
              </a:extLst>
            </p:cNvPr>
            <p:cNvSpPr txBox="1"/>
            <p:nvPr/>
          </p:nvSpPr>
          <p:spPr>
            <a:xfrm>
              <a:off x="9040317" y="620435"/>
              <a:ext cx="92653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  K562  cells  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921EFC8D-60CB-7898-21C6-1C30988498F6}"/>
                </a:ext>
              </a:extLst>
            </p:cNvPr>
            <p:cNvGrpSpPr/>
            <p:nvPr/>
          </p:nvGrpSpPr>
          <p:grpSpPr>
            <a:xfrm>
              <a:off x="9131412" y="835528"/>
              <a:ext cx="987194" cy="369332"/>
              <a:chOff x="9264675" y="3166129"/>
              <a:chExt cx="1504961" cy="393688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1B2DBEA7-E2E0-5A82-C57A-1A2AA3980982}"/>
                  </a:ext>
                </a:extLst>
              </p:cNvPr>
              <p:cNvCxnSpPr/>
              <p:nvPr/>
            </p:nvCxnSpPr>
            <p:spPr>
              <a:xfrm>
                <a:off x="9264675" y="3299581"/>
                <a:ext cx="207257" cy="0"/>
              </a:xfrm>
              <a:prstGeom prst="line">
                <a:avLst/>
              </a:prstGeom>
              <a:ln w="2222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56C29D1-E3FB-CDB5-21B6-F44E936AA323}"/>
                  </a:ext>
                </a:extLst>
              </p:cNvPr>
              <p:cNvSpPr txBox="1"/>
              <p:nvPr/>
            </p:nvSpPr>
            <p:spPr>
              <a:xfrm>
                <a:off x="9400652" y="3166129"/>
                <a:ext cx="1368984" cy="393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Control</a:t>
                </a:r>
              </a:p>
              <a:p>
                <a:r>
                  <a:rPr lang="en-US" sz="900" b="1" dirty="0"/>
                  <a:t>Anti-CD19-APC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3B3E330D-A0E4-1B98-A906-0EA8666D6D31}"/>
                  </a:ext>
                </a:extLst>
              </p:cNvPr>
              <p:cNvCxnSpPr/>
              <p:nvPr/>
            </p:nvCxnSpPr>
            <p:spPr>
              <a:xfrm>
                <a:off x="9267098" y="3451981"/>
                <a:ext cx="207257" cy="0"/>
              </a:xfrm>
              <a:prstGeom prst="line">
                <a:avLst/>
              </a:prstGeom>
              <a:ln w="2222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54CADC2-C18A-C290-FB25-4D79E64185F2}"/>
                </a:ext>
              </a:extLst>
            </p:cNvPr>
            <p:cNvSpPr/>
            <p:nvPr/>
          </p:nvSpPr>
          <p:spPr>
            <a:xfrm>
              <a:off x="7352637" y="581731"/>
              <a:ext cx="2875096" cy="149864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AACDD35E-B227-B86F-05AD-564F2BB502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0562233"/>
              </p:ext>
            </p:extLst>
          </p:nvPr>
        </p:nvGraphicFramePr>
        <p:xfrm>
          <a:off x="7325686" y="2052337"/>
          <a:ext cx="2477277" cy="19244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811196" imgH="2960684" progId="Prism9.Document">
                  <p:embed/>
                </p:oleObj>
              </mc:Choice>
              <mc:Fallback>
                <p:oleObj name="Prism 9" r:id="rId12" imgW="3811196" imgH="296068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325686" y="2052337"/>
                        <a:ext cx="2477277" cy="19244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0D38D0C0-B78B-8E5D-476E-D7B951BF40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1413563"/>
              </p:ext>
            </p:extLst>
          </p:nvPr>
        </p:nvGraphicFramePr>
        <p:xfrm>
          <a:off x="7382647" y="3903642"/>
          <a:ext cx="2424634" cy="19244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730206" imgH="2960684" progId="Prism9.Document">
                  <p:embed/>
                </p:oleObj>
              </mc:Choice>
              <mc:Fallback>
                <p:oleObj name="Prism 9" r:id="rId14" imgW="3730206" imgH="296068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382647" y="3903642"/>
                        <a:ext cx="2424634" cy="19244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58E4BFA9-0CB8-B75B-BE30-47218889F5AE}"/>
              </a:ext>
            </a:extLst>
          </p:cNvPr>
          <p:cNvSpPr txBox="1"/>
          <p:nvPr/>
        </p:nvSpPr>
        <p:spPr>
          <a:xfrm>
            <a:off x="1076017" y="587581"/>
            <a:ext cx="3509294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                                                 C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B                                                          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48F390E-6281-4FAF-CB5B-3B1DFF310AB9}"/>
              </a:ext>
            </a:extLst>
          </p:cNvPr>
          <p:cNvSpPr txBox="1"/>
          <p:nvPr/>
        </p:nvSpPr>
        <p:spPr>
          <a:xfrm>
            <a:off x="7116838" y="587581"/>
            <a:ext cx="330540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F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1900925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AEDC894-105D-640E-E119-13F885D5DC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2516335"/>
              </p:ext>
            </p:extLst>
          </p:nvPr>
        </p:nvGraphicFramePr>
        <p:xfrm>
          <a:off x="1047750" y="2879725"/>
          <a:ext cx="4770438" cy="218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358952" imgH="2916769" progId="Prism9.Document">
                  <p:embed/>
                </p:oleObj>
              </mc:Choice>
              <mc:Fallback>
                <p:oleObj name="Prism 9" r:id="rId2" imgW="6358952" imgH="2916769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AEDC894-105D-640E-E119-13F885D5DC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7750" y="2879725"/>
                        <a:ext cx="4770438" cy="218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7C24C91-BAE4-BB27-E17B-53592FAD4715}"/>
              </a:ext>
            </a:extLst>
          </p:cNvPr>
          <p:cNvSpPr txBox="1"/>
          <p:nvPr/>
        </p:nvSpPr>
        <p:spPr>
          <a:xfrm>
            <a:off x="1088912" y="498224"/>
            <a:ext cx="5274201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                                                                                C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B                                                                                          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7BE2209-6E42-4D4B-A855-5AD9BEB95ED6}"/>
              </a:ext>
            </a:extLst>
          </p:cNvPr>
          <p:cNvSpPr txBox="1"/>
          <p:nvPr/>
        </p:nvSpPr>
        <p:spPr>
          <a:xfrm>
            <a:off x="125790" y="41410"/>
            <a:ext cx="2535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2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1A0F784-FF3B-1F49-2B27-045557FDC6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583429"/>
              </p:ext>
            </p:extLst>
          </p:nvPr>
        </p:nvGraphicFramePr>
        <p:xfrm>
          <a:off x="1006573" y="646495"/>
          <a:ext cx="4769214" cy="21875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6358952" imgH="2916769" progId="Prism9.Document">
                  <p:embed/>
                </p:oleObj>
              </mc:Choice>
              <mc:Fallback>
                <p:oleObj name="Prism 9" r:id="rId4" imgW="6358952" imgH="2916769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1A0F784-FF3B-1F49-2B27-045557FDC6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06573" y="646495"/>
                        <a:ext cx="4769214" cy="21875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A33BE70-93F9-04E1-DB1F-946789CEDC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7570174"/>
              </p:ext>
            </p:extLst>
          </p:nvPr>
        </p:nvGraphicFramePr>
        <p:xfrm>
          <a:off x="5776913" y="646113"/>
          <a:ext cx="4770437" cy="218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6358952" imgH="2916769" progId="Prism9.Document">
                  <p:embed/>
                </p:oleObj>
              </mc:Choice>
              <mc:Fallback>
                <p:oleObj name="Prism 9" r:id="rId6" imgW="6358952" imgH="2916769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A33BE70-93F9-04E1-DB1F-946789CEDC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776913" y="646113"/>
                        <a:ext cx="4770437" cy="218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9C67237-6D88-0C78-0372-2B2B81FE6C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201643"/>
              </p:ext>
            </p:extLst>
          </p:nvPr>
        </p:nvGraphicFramePr>
        <p:xfrm>
          <a:off x="5776913" y="2882900"/>
          <a:ext cx="4770437" cy="218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6358952" imgH="2916769" progId="Prism9.Document">
                  <p:embed/>
                </p:oleObj>
              </mc:Choice>
              <mc:Fallback>
                <p:oleObj name="Prism 9" r:id="rId8" imgW="6358952" imgH="2916769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C9C67237-6D88-0C78-0372-2B2B81FE6C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76913" y="2882900"/>
                        <a:ext cx="4770437" cy="218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B1BACDD-2A6E-1C80-E428-4318337016BC}"/>
              </a:ext>
            </a:extLst>
          </p:cNvPr>
          <p:cNvSpPr txBox="1"/>
          <p:nvPr/>
        </p:nvSpPr>
        <p:spPr>
          <a:xfrm>
            <a:off x="1190625" y="5284078"/>
            <a:ext cx="98107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2. </a:t>
            </a:r>
            <a:r>
              <a:rPr lang="en-US" sz="1200" dirty="0"/>
              <a:t>Effect of S compounds on cell death of Raji induced by Jurkat-PD1-CAR-CD19. Effect of S compounds on cell death of Raji  (</a:t>
            </a:r>
            <a:r>
              <a:rPr lang="en-US" sz="1200" b="1" dirty="0"/>
              <a:t>A</a:t>
            </a:r>
            <a:r>
              <a:rPr lang="en-US" sz="1200" dirty="0"/>
              <a:t>) or Raji-PD-L1 (</a:t>
            </a:r>
            <a:r>
              <a:rPr lang="en-US" sz="1200" b="1" dirty="0"/>
              <a:t>B</a:t>
            </a:r>
            <a:r>
              <a:rPr lang="en-US" sz="1200" dirty="0"/>
              <a:t>) when co-culturing Jurkat-PD1 cells. Effect of S compounds on cell death of Raji (</a:t>
            </a:r>
            <a:r>
              <a:rPr lang="en-US" sz="1200" b="1" dirty="0"/>
              <a:t>C</a:t>
            </a:r>
            <a:r>
              <a:rPr lang="en-US" sz="1200" dirty="0"/>
              <a:t>) or Raji-PD-L1 (</a:t>
            </a:r>
            <a:r>
              <a:rPr lang="en-US" sz="1200" b="1" dirty="0"/>
              <a:t>D</a:t>
            </a:r>
            <a:r>
              <a:rPr lang="en-US" sz="1200" dirty="0"/>
              <a:t>) when co-culturing with </a:t>
            </a:r>
            <a:r>
              <a:rPr lang="en-US" sz="1200"/>
              <a:t>Jurkat-PD1-CAR-CD19 cells. </a:t>
            </a:r>
            <a:r>
              <a:rPr lang="en-US" sz="1200" dirty="0"/>
              <a:t>Annexin V-PE and helix-NR-APC were used to stained dead cells of CD19+ Raji cells using flow cytometry and result labeled with * when P values of T test was less than 0.05. Details of experimental procedures are given in Materials and Methods.</a:t>
            </a:r>
          </a:p>
        </p:txBody>
      </p:sp>
    </p:spTree>
    <p:extLst>
      <p:ext uri="{BB962C8B-B14F-4D97-AF65-F5344CB8AC3E}">
        <p14:creationId xmlns:p14="http://schemas.microsoft.com/office/powerpoint/2010/main" val="22506122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E00122C-12A0-41E6-949F-0F473A78D16A}"/>
              </a:ext>
            </a:extLst>
          </p:cNvPr>
          <p:cNvSpPr txBox="1"/>
          <p:nvPr/>
        </p:nvSpPr>
        <p:spPr>
          <a:xfrm>
            <a:off x="9603" y="34093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0C3A464-DA87-47BA-8B14-EE16BA699F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3706996"/>
              </p:ext>
            </p:extLst>
          </p:nvPr>
        </p:nvGraphicFramePr>
        <p:xfrm>
          <a:off x="2446413" y="658324"/>
          <a:ext cx="4086225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448988" imgH="2945566" progId="Prism9.Document">
                  <p:embed/>
                </p:oleObj>
              </mc:Choice>
              <mc:Fallback>
                <p:oleObj name="Prism 9" r:id="rId2" imgW="5448988" imgH="2945566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0C3A464-DA87-47BA-8B14-EE16BA699F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46413" y="658324"/>
                        <a:ext cx="4086225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BCCB01B-52EC-4C06-9118-413472C206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8134492"/>
              </p:ext>
            </p:extLst>
          </p:nvPr>
        </p:nvGraphicFramePr>
        <p:xfrm>
          <a:off x="2446412" y="3088111"/>
          <a:ext cx="4086225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5448988" imgH="2945566" progId="Prism9.Document">
                  <p:embed/>
                </p:oleObj>
              </mc:Choice>
              <mc:Fallback>
                <p:oleObj name="Prism 9" r:id="rId4" imgW="5448988" imgH="2945566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BCCB01B-52EC-4C06-9118-413472C206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46412" y="3088111"/>
                        <a:ext cx="4086225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7D79A0B8-F508-3164-10A4-22E733F3EAB9}"/>
              </a:ext>
            </a:extLst>
          </p:cNvPr>
          <p:cNvSpPr txBox="1"/>
          <p:nvPr/>
        </p:nvSpPr>
        <p:spPr>
          <a:xfrm>
            <a:off x="1499629" y="5494527"/>
            <a:ext cx="934871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igure S2. </a:t>
            </a:r>
            <a:r>
              <a:rPr lang="en-US" sz="1200" dirty="0"/>
              <a:t>Effects of YIV-906 on CD69 expression (median Fluorescence) of Jurkat PD1 cells, when incubated with PD-L1 overexpressed Raji cells (</a:t>
            </a:r>
            <a:r>
              <a:rPr lang="en-US" sz="1200" b="1" dirty="0"/>
              <a:t>A</a:t>
            </a:r>
            <a:r>
              <a:rPr lang="en-US" sz="1200" dirty="0"/>
              <a:t>) or Raji PD-L1 cells (</a:t>
            </a:r>
            <a:r>
              <a:rPr lang="en-US" sz="1200" b="1" dirty="0"/>
              <a:t>B</a:t>
            </a:r>
            <a:r>
              <a:rPr lang="en-US" sz="1200" dirty="0"/>
              <a:t>) in the</a:t>
            </a:r>
            <a:r>
              <a:rPr lang="en-US" sz="1200" dirty="0">
                <a:solidFill>
                  <a:srgbClr val="FF0000"/>
                </a:solidFill>
              </a:rPr>
              <a:t> </a:t>
            </a:r>
            <a:r>
              <a:rPr lang="en-US" sz="1200" dirty="0"/>
              <a:t>absence or presence of SEE antigen, are determined following 48h incubation. Effects of YIV-906 and S on CD69+ of CD4+(</a:t>
            </a:r>
            <a:r>
              <a:rPr lang="en-US" sz="1200" b="1" dirty="0"/>
              <a:t>C</a:t>
            </a:r>
            <a:r>
              <a:rPr lang="en-US" sz="1200" dirty="0"/>
              <a:t>) and CD8+(</a:t>
            </a:r>
            <a:r>
              <a:rPr lang="en-US" sz="1200" b="1" dirty="0"/>
              <a:t>D</a:t>
            </a:r>
            <a:r>
              <a:rPr lang="en-US" sz="1200" dirty="0"/>
              <a:t>) cells isolated from mouse spleen following 48h incubation. The expression of CD69 was determined by flow cytometry in which FITC conjugated anti-CD69 was used to determine the expression of CD69 protein on the membrane of Jurkat cells and PE conjugated anti-PD1 was used to gate Jurkat PD1 cell from the mixture of Jurkat/Raji cells. CD4 and CD8 cells were gated using </a:t>
            </a:r>
            <a:r>
              <a:rPr lang="en-US" sz="1200" dirty="0" err="1"/>
              <a:t>PerCP</a:t>
            </a:r>
            <a:r>
              <a:rPr lang="en-US" sz="1200" dirty="0"/>
              <a:t> and APC conjugated antibodies. Details of experimental procedures are given in Materials and Methods.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3CCE820-7CB7-7924-E365-D2BF61563A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9033666"/>
              </p:ext>
            </p:extLst>
          </p:nvPr>
        </p:nvGraphicFramePr>
        <p:xfrm>
          <a:off x="7061978" y="901720"/>
          <a:ext cx="2252432" cy="2239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465280" imgH="3445553" progId="Prism7.Document">
                  <p:embed/>
                </p:oleObj>
              </mc:Choice>
              <mc:Fallback>
                <p:oleObj name="Prism 7" r:id="rId6" imgW="3465280" imgH="3445553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FB74AE0-2A3B-0959-C3EC-F1BBF2B816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061978" y="901720"/>
                        <a:ext cx="2252432" cy="2239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40BDFF7-4958-7B55-836F-BF1BCC9FC9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2124004"/>
              </p:ext>
            </p:extLst>
          </p:nvPr>
        </p:nvGraphicFramePr>
        <p:xfrm>
          <a:off x="7061978" y="3337945"/>
          <a:ext cx="2252432" cy="2239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465280" imgH="3445553" progId="Prism9.Document">
                  <p:embed/>
                </p:oleObj>
              </mc:Choice>
              <mc:Fallback>
                <p:oleObj name="Prism 9" r:id="rId8" imgW="3465280" imgH="3445553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7DBDE975-10FD-B504-FA44-AE0AA174AD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061978" y="3337945"/>
                        <a:ext cx="2252432" cy="2239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99F6328E-A847-757D-F985-06BCFE2336E2}"/>
              </a:ext>
            </a:extLst>
          </p:cNvPr>
          <p:cNvSpPr txBox="1"/>
          <p:nvPr/>
        </p:nvSpPr>
        <p:spPr>
          <a:xfrm>
            <a:off x="2446412" y="658324"/>
            <a:ext cx="498974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                                                                                     C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B                                                                                     D</a:t>
            </a:r>
          </a:p>
        </p:txBody>
      </p:sp>
    </p:spTree>
    <p:extLst>
      <p:ext uri="{BB962C8B-B14F-4D97-AF65-F5344CB8AC3E}">
        <p14:creationId xmlns:p14="http://schemas.microsoft.com/office/powerpoint/2010/main" val="26332332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8672811-A64D-9103-DC0A-0F6A013BD3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0363807"/>
              </p:ext>
            </p:extLst>
          </p:nvPr>
        </p:nvGraphicFramePr>
        <p:xfrm>
          <a:off x="4345677" y="537516"/>
          <a:ext cx="3500645" cy="22183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667527" imgH="2957805" progId="Prism9.Document">
                  <p:embed/>
                </p:oleObj>
              </mc:Choice>
              <mc:Fallback>
                <p:oleObj name="Prism 9" r:id="rId2" imgW="4667527" imgH="295780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45677" y="537516"/>
                        <a:ext cx="3500645" cy="22183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40B4B52-A2A6-341D-1035-D49B075DFC4F}"/>
              </a:ext>
            </a:extLst>
          </p:cNvPr>
          <p:cNvSpPr txBox="1"/>
          <p:nvPr/>
        </p:nvSpPr>
        <p:spPr>
          <a:xfrm>
            <a:off x="221039" y="8844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A92F44-A42A-D606-5506-ACA3E608AFE8}"/>
              </a:ext>
            </a:extLst>
          </p:cNvPr>
          <p:cNvSpPr txBox="1"/>
          <p:nvPr/>
        </p:nvSpPr>
        <p:spPr>
          <a:xfrm>
            <a:off x="724896" y="5356870"/>
            <a:ext cx="1081494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. </a:t>
            </a:r>
            <a:r>
              <a:rPr lang="en-US" sz="1200" dirty="0"/>
              <a:t>Effect of 11R-VIVIT (NFAT inhibitor) on NFAT mediated luciferase activity of Jurkat-PD1 cells co-culturing with Raji or Raji-PD-L1 cells in presence of SEE and YIV-906/</a:t>
            </a:r>
            <a:r>
              <a:rPr lang="en-US" sz="1200" b="1" dirty="0"/>
              <a:t>S</a:t>
            </a:r>
            <a:r>
              <a:rPr lang="en-US" sz="1200" dirty="0"/>
              <a:t> . (</a:t>
            </a:r>
            <a:r>
              <a:rPr lang="en-US" sz="1200" b="1" dirty="0"/>
              <a:t>A</a:t>
            </a:r>
            <a:r>
              <a:rPr lang="en-US" sz="1200" dirty="0"/>
              <a:t>) Inhibitory effect of 11R-VIVIT on NFAT mediated luciferase activity of Jurkat-PD1 cells co-culturing with Raji or Raji-PD-L1 cells in presence of SEE. (</a:t>
            </a:r>
            <a:r>
              <a:rPr lang="en-US" sz="1200" b="1" dirty="0"/>
              <a:t>B</a:t>
            </a:r>
            <a:r>
              <a:rPr lang="en-US" sz="1200" dirty="0"/>
              <a:t>) Effect of 11R-VIVIT (25uM) on NFAT mediated luciferase activity of Jurkat-PD1 cells co-culturing with Raji in presence of SEE and YIV-906/</a:t>
            </a:r>
            <a:r>
              <a:rPr lang="en-US" sz="1200" b="1" dirty="0"/>
              <a:t>S</a:t>
            </a:r>
            <a:r>
              <a:rPr lang="en-US" sz="1200" dirty="0"/>
              <a:t>. (</a:t>
            </a:r>
            <a:r>
              <a:rPr lang="en-US" sz="1200" b="1" dirty="0"/>
              <a:t>C</a:t>
            </a:r>
            <a:r>
              <a:rPr lang="en-US" sz="1200" dirty="0"/>
              <a:t>) Effect of 11R-VIVIT (25uM) on NFAT mediated luciferase activity of Jurkat-PD1 cells co-culturing with Raji in presence of SEE and YIV-906/</a:t>
            </a:r>
            <a:r>
              <a:rPr lang="en-US" sz="1200" b="1" dirty="0"/>
              <a:t>S</a:t>
            </a:r>
            <a:r>
              <a:rPr lang="en-US" sz="1200" dirty="0"/>
              <a:t>. Details of experimental procedures are given in Materials and Methods.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74C71B0-1617-6C61-F80E-6076EFB5ED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3419284"/>
              </p:ext>
            </p:extLst>
          </p:nvPr>
        </p:nvGraphicFramePr>
        <p:xfrm>
          <a:off x="2433027" y="2891757"/>
          <a:ext cx="3699341" cy="23098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932454" imgH="3079832" progId="Prism9.Document">
                  <p:embed/>
                </p:oleObj>
              </mc:Choice>
              <mc:Fallback>
                <p:oleObj name="Prism 9" r:id="rId4" imgW="4932454" imgH="307983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33027" y="2891757"/>
                        <a:ext cx="3699341" cy="23098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CAF90F0-DBE2-1558-EE43-74FE5FE50C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1763934"/>
              </p:ext>
            </p:extLst>
          </p:nvPr>
        </p:nvGraphicFramePr>
        <p:xfrm>
          <a:off x="6132368" y="2886919"/>
          <a:ext cx="3699341" cy="23098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932454" imgH="3079832" progId="Prism9.Document">
                  <p:embed/>
                </p:oleObj>
              </mc:Choice>
              <mc:Fallback>
                <p:oleObj name="Prism 9" r:id="rId6" imgW="4932454" imgH="307983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132368" y="2886919"/>
                        <a:ext cx="3699341" cy="23098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385542B0-2401-A8F4-A6AF-E0C2576D1408}"/>
              </a:ext>
            </a:extLst>
          </p:cNvPr>
          <p:cNvSpPr txBox="1"/>
          <p:nvPr/>
        </p:nvSpPr>
        <p:spPr>
          <a:xfrm>
            <a:off x="4233333" y="40162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F401D6-47D6-838B-3DBE-7C573AE4F748}"/>
              </a:ext>
            </a:extLst>
          </p:cNvPr>
          <p:cNvSpPr txBox="1"/>
          <p:nvPr/>
        </p:nvSpPr>
        <p:spPr>
          <a:xfrm>
            <a:off x="2433027" y="2838538"/>
            <a:ext cx="4086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                                                                     C</a:t>
            </a:r>
          </a:p>
        </p:txBody>
      </p:sp>
    </p:spTree>
    <p:extLst>
      <p:ext uri="{BB962C8B-B14F-4D97-AF65-F5344CB8AC3E}">
        <p14:creationId xmlns:p14="http://schemas.microsoft.com/office/powerpoint/2010/main" val="17943896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D15D678-25D0-417F-A319-3351E53557E8}"/>
              </a:ext>
            </a:extLst>
          </p:cNvPr>
          <p:cNvSpPr txBox="1"/>
          <p:nvPr/>
        </p:nvSpPr>
        <p:spPr>
          <a:xfrm>
            <a:off x="221039" y="8844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DF9E50D-56F4-083B-A7CB-CA25159A02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25" t="40354"/>
          <a:stretch/>
        </p:blipFill>
        <p:spPr>
          <a:xfrm>
            <a:off x="2421467" y="426456"/>
            <a:ext cx="7504272" cy="300254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892A47-C39B-7C80-81F7-F049C4C8E4B9}"/>
              </a:ext>
            </a:extLst>
          </p:cNvPr>
          <p:cNvSpPr txBox="1"/>
          <p:nvPr/>
        </p:nvSpPr>
        <p:spPr>
          <a:xfrm>
            <a:off x="1080448" y="5567366"/>
            <a:ext cx="1003110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45720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4 (A) 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hemical identification of fractions of 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fter C18 column fractionation and their impacts on protein phosphorylation for Lck, Zap70, Lat, Fyn/</a:t>
            </a:r>
            <a:r>
              <a:rPr lang="en-US" sz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rc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Pyk2.  Equivalent concentrations, 10mg/ml, were used for LC-MS analysis. Identified chemicals (putative), based on their mass and mass of their fragments, were listed under each fraction.  Non-identified chemicals were not listed in this figure.  Fractions could induce phosphorylation of specific protein was indicted as red upward arrow. Effects of S compounds on NFAT-mediated transcriptional activity of Jurkat-PD1 cells (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nd Jurkat-PD1 TCRαβ knock-out cells (</a:t>
            </a:r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re also shown. Details of experimental procedures are given in Materials and Metho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B60FA06-338D-0087-840D-92CA903D7D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3980474"/>
              </p:ext>
            </p:extLst>
          </p:nvPr>
        </p:nvGraphicFramePr>
        <p:xfrm>
          <a:off x="2107403" y="3545229"/>
          <a:ext cx="4083717" cy="1983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6282642" imgH="3052115" progId="Prism9.Document">
                  <p:embed/>
                </p:oleObj>
              </mc:Choice>
              <mc:Fallback>
                <p:oleObj name="Prism 9" r:id="rId3" imgW="6282642" imgH="305211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DB60FA06-338D-0087-840D-92CA903D7D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07403" y="3545229"/>
                        <a:ext cx="4083717" cy="1983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2BCD65D-3D12-9D41-32DB-65BCAE8E02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6318327"/>
              </p:ext>
            </p:extLst>
          </p:nvPr>
        </p:nvGraphicFramePr>
        <p:xfrm>
          <a:off x="6150495" y="3545229"/>
          <a:ext cx="4083717" cy="1983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6282642" imgH="3052115" progId="Prism9.Document">
                  <p:embed/>
                </p:oleObj>
              </mc:Choice>
              <mc:Fallback>
                <p:oleObj name="Prism 9" r:id="rId5" imgW="6282642" imgH="305211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82BCD65D-3D12-9D41-32DB-65BCAE8E02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50495" y="3545229"/>
                        <a:ext cx="4083717" cy="1983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5A5EABD-5E9D-D6C9-4F22-3DB8C21DA8D5}"/>
              </a:ext>
            </a:extLst>
          </p:cNvPr>
          <p:cNvSpPr txBox="1"/>
          <p:nvPr/>
        </p:nvSpPr>
        <p:spPr>
          <a:xfrm>
            <a:off x="2107403" y="3484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B8A229-F107-7238-3329-B308C72FD530}"/>
              </a:ext>
            </a:extLst>
          </p:cNvPr>
          <p:cNvSpPr txBox="1"/>
          <p:nvPr/>
        </p:nvSpPr>
        <p:spPr>
          <a:xfrm>
            <a:off x="2107403" y="3506967"/>
            <a:ext cx="4453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                                                                            C</a:t>
            </a:r>
          </a:p>
        </p:txBody>
      </p:sp>
    </p:spTree>
    <p:extLst>
      <p:ext uri="{BB962C8B-B14F-4D97-AF65-F5344CB8AC3E}">
        <p14:creationId xmlns:p14="http://schemas.microsoft.com/office/powerpoint/2010/main" val="19531550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73A838F-9C24-475D-82B2-D7F18D8B50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8997460"/>
              </p:ext>
            </p:extLst>
          </p:nvPr>
        </p:nvGraphicFramePr>
        <p:xfrm>
          <a:off x="6142037" y="368031"/>
          <a:ext cx="3644537" cy="22275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859383" imgH="2970043" progId="Prism9.Document">
                  <p:embed/>
                </p:oleObj>
              </mc:Choice>
              <mc:Fallback>
                <p:oleObj name="Prism 9" r:id="rId2" imgW="4859383" imgH="2970043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773A838F-9C24-475D-82B2-D7F18D8B50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42037" y="368031"/>
                        <a:ext cx="3644537" cy="22275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4C2795B2-1F97-482B-B0BE-CCE5586053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1661777"/>
              </p:ext>
            </p:extLst>
          </p:nvPr>
        </p:nvGraphicFramePr>
        <p:xfrm>
          <a:off x="2557463" y="2757488"/>
          <a:ext cx="2771775" cy="2571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93851" imgH="3428634" progId="Prism9.Document">
                  <p:embed/>
                </p:oleObj>
              </mc:Choice>
              <mc:Fallback>
                <p:oleObj name="Prism 9" r:id="rId4" imgW="3693851" imgH="3428634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4C2795B2-1F97-482B-B0BE-CCE5586053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57463" y="2757488"/>
                        <a:ext cx="2771775" cy="2571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4A0C98B-DB4F-447D-BDEE-959512863E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2002529"/>
              </p:ext>
            </p:extLst>
          </p:nvPr>
        </p:nvGraphicFramePr>
        <p:xfrm>
          <a:off x="6145213" y="2757488"/>
          <a:ext cx="2765425" cy="2592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685932" imgH="3454552" progId="Prism9.Document">
                  <p:embed/>
                </p:oleObj>
              </mc:Choice>
              <mc:Fallback>
                <p:oleObj name="Prism 9" r:id="rId6" imgW="3685932" imgH="3454552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4A0C98B-DB4F-447D-BDEE-959512863E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145213" y="2757488"/>
                        <a:ext cx="2765425" cy="2592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79FF52C5-AF95-42D5-B5DF-C2BC7F62B5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9591647"/>
              </p:ext>
            </p:extLst>
          </p:nvPr>
        </p:nvGraphicFramePr>
        <p:xfrm>
          <a:off x="2517380" y="368031"/>
          <a:ext cx="3644537" cy="22275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859383" imgH="2970043" progId="Prism9.Document">
                  <p:embed/>
                </p:oleObj>
              </mc:Choice>
              <mc:Fallback>
                <p:oleObj name="Prism 9" r:id="rId8" imgW="4859383" imgH="2970043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79FF52C5-AF95-42D5-B5DF-C2BC7F62B5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517380" y="368031"/>
                        <a:ext cx="3644537" cy="22275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1BB88C7-4885-59AC-59B8-055B2C2393AE}"/>
              </a:ext>
            </a:extLst>
          </p:cNvPr>
          <p:cNvSpPr txBox="1"/>
          <p:nvPr/>
        </p:nvSpPr>
        <p:spPr>
          <a:xfrm>
            <a:off x="2699785" y="368031"/>
            <a:ext cx="3996607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                                                                  B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C                                                                   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7669ED-FF9F-51ED-BBF1-AEF485414604}"/>
              </a:ext>
            </a:extLst>
          </p:cNvPr>
          <p:cNvSpPr txBox="1"/>
          <p:nvPr/>
        </p:nvSpPr>
        <p:spPr>
          <a:xfrm>
            <a:off x="195016" y="184156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2CDF5E1-F6B5-F5CD-5D08-AEAA2E00B7D8}"/>
              </a:ext>
            </a:extLst>
          </p:cNvPr>
          <p:cNvSpPr txBox="1"/>
          <p:nvPr/>
        </p:nvSpPr>
        <p:spPr>
          <a:xfrm>
            <a:off x="1819275" y="5414963"/>
            <a:ext cx="89439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5</a:t>
            </a:r>
            <a:r>
              <a:rPr lang="en-US" sz="1200" dirty="0"/>
              <a:t>. Effect of YIV-906 and its components on SHP1 and SHP2 enzymatic activity. Effect of YIV-906 and its component herbs on SHP1 (</a:t>
            </a:r>
            <a:r>
              <a:rPr lang="en-US" sz="1200" b="1" dirty="0"/>
              <a:t>A</a:t>
            </a:r>
            <a:r>
              <a:rPr lang="en-US" sz="1200" dirty="0"/>
              <a:t>) and SHP2 (</a:t>
            </a:r>
            <a:r>
              <a:rPr lang="en-US" sz="1200" b="1" dirty="0"/>
              <a:t>B</a:t>
            </a:r>
            <a:r>
              <a:rPr lang="en-US" sz="1200" dirty="0"/>
              <a:t>) activity. Effect of G compounds, 40uM (</a:t>
            </a:r>
            <a:r>
              <a:rPr lang="en-US" sz="1200" b="1" dirty="0"/>
              <a:t>C</a:t>
            </a:r>
            <a:r>
              <a:rPr lang="en-US" sz="1200" dirty="0"/>
              <a:t>) and S compounds, 40uM (</a:t>
            </a:r>
            <a:r>
              <a:rPr lang="en-US" sz="1200" b="1" dirty="0"/>
              <a:t>D</a:t>
            </a:r>
            <a:r>
              <a:rPr lang="en-US" sz="1200" dirty="0"/>
              <a:t>) on SHP1 and SHP2 activity. Details of experimental procedures are given in Materials and Methods.</a:t>
            </a:r>
          </a:p>
        </p:txBody>
      </p:sp>
    </p:spTree>
    <p:extLst>
      <p:ext uri="{BB962C8B-B14F-4D97-AF65-F5344CB8AC3E}">
        <p14:creationId xmlns:p14="http://schemas.microsoft.com/office/powerpoint/2010/main" val="24468310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98D0E49-8A23-4584-AE97-0A17F140F2A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45" r="7789"/>
          <a:stretch/>
        </p:blipFill>
        <p:spPr>
          <a:xfrm>
            <a:off x="5195248" y="1675263"/>
            <a:ext cx="1346578" cy="7697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6EAA064-5925-4E3B-BE53-EF00EF55BC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07" t="3962" r="12703"/>
          <a:stretch/>
        </p:blipFill>
        <p:spPr>
          <a:xfrm>
            <a:off x="5195249" y="2579426"/>
            <a:ext cx="1346578" cy="127379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1E8FC92-7730-4A39-B0E8-01C079DBC6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90" t="679"/>
          <a:stretch/>
        </p:blipFill>
        <p:spPr>
          <a:xfrm rot="10800000">
            <a:off x="5195248" y="3955773"/>
            <a:ext cx="1358803" cy="120006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0CE21FE-6E43-4153-95D4-AEFB48B90B23}"/>
              </a:ext>
            </a:extLst>
          </p:cNvPr>
          <p:cNvSpPr txBox="1"/>
          <p:nvPr/>
        </p:nvSpPr>
        <p:spPr>
          <a:xfrm rot="16200000">
            <a:off x="5402123" y="647641"/>
            <a:ext cx="776175" cy="12803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/>
              <a:t>Jurkat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SHP1-KO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SHP2-KO</a:t>
            </a:r>
          </a:p>
          <a:p>
            <a:pPr>
              <a:lnSpc>
                <a:spcPct val="200000"/>
              </a:lnSpc>
            </a:pPr>
            <a:r>
              <a:rPr lang="en-US" sz="1000" b="1" dirty="0"/>
              <a:t>SHP1/2-K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2B68E8-F2E0-41B0-8900-F905F036C290}"/>
              </a:ext>
            </a:extLst>
          </p:cNvPr>
          <p:cNvSpPr txBox="1"/>
          <p:nvPr/>
        </p:nvSpPr>
        <p:spPr>
          <a:xfrm>
            <a:off x="4463893" y="1982450"/>
            <a:ext cx="731354" cy="2677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/>
              <a:t>SHP2</a:t>
            </a:r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r>
              <a:rPr lang="en-US" sz="1400" b="1" dirty="0"/>
              <a:t>SHP1</a:t>
            </a:r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r>
              <a:rPr lang="en-US" sz="1400" b="1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C8851A-0CCA-4F3B-BFAE-A495FC84EDC6}"/>
              </a:ext>
            </a:extLst>
          </p:cNvPr>
          <p:cNvSpPr txBox="1"/>
          <p:nvPr/>
        </p:nvSpPr>
        <p:spPr>
          <a:xfrm>
            <a:off x="125790" y="41410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5EE7A2-A72D-2ECD-EC86-73FA9489F90C}"/>
              </a:ext>
            </a:extLst>
          </p:cNvPr>
          <p:cNvSpPr txBox="1"/>
          <p:nvPr/>
        </p:nvSpPr>
        <p:spPr>
          <a:xfrm>
            <a:off x="2519363" y="5613299"/>
            <a:ext cx="8277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6</a:t>
            </a:r>
            <a:r>
              <a:rPr lang="en-US" sz="1200" dirty="0"/>
              <a:t>. Western analysis for SHP2 and SHP1 protein expression of SHP1 and/or SHP2 knockout Jurkat cells. Details of experimental procedures are given in Materials and Methods.</a:t>
            </a:r>
          </a:p>
        </p:txBody>
      </p:sp>
    </p:spTree>
    <p:extLst>
      <p:ext uri="{BB962C8B-B14F-4D97-AF65-F5344CB8AC3E}">
        <p14:creationId xmlns:p14="http://schemas.microsoft.com/office/powerpoint/2010/main" val="21168492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EDBB84E-B803-4FD7-AF10-1DEB3B40B0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5335212"/>
              </p:ext>
            </p:extLst>
          </p:nvPr>
        </p:nvGraphicFramePr>
        <p:xfrm>
          <a:off x="729526" y="1281278"/>
          <a:ext cx="2198817" cy="177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64695" imgH="2953125" progId="Prism9.Document">
                  <p:embed/>
                </p:oleObj>
              </mc:Choice>
              <mc:Fallback>
                <p:oleObj name="Prism 9" r:id="rId2" imgW="3664695" imgH="2953125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EDBB84E-B803-4FD7-AF10-1DEB3B40B0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9526" y="1281278"/>
                        <a:ext cx="2198817" cy="177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8FA0397-4873-4BC4-AA74-347EC6441A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3728918"/>
              </p:ext>
            </p:extLst>
          </p:nvPr>
        </p:nvGraphicFramePr>
        <p:xfrm>
          <a:off x="2816916" y="1281279"/>
          <a:ext cx="2265552" cy="177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75920" imgH="2953125" progId="Prism9.Document">
                  <p:embed/>
                </p:oleObj>
              </mc:Choice>
              <mc:Fallback>
                <p:oleObj name="Prism 9" r:id="rId4" imgW="3775920" imgH="2953125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8FA0397-4873-4BC4-AA74-347EC6441A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16916" y="1281279"/>
                        <a:ext cx="2265552" cy="177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9C4592C-7F97-497D-968D-C50F4F74DB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3319022"/>
              </p:ext>
            </p:extLst>
          </p:nvPr>
        </p:nvGraphicFramePr>
        <p:xfrm>
          <a:off x="9327270" y="1281281"/>
          <a:ext cx="2238124" cy="177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730206" imgH="2953125" progId="Prism9.Document">
                  <p:embed/>
                </p:oleObj>
              </mc:Choice>
              <mc:Fallback>
                <p:oleObj name="Prism 9" r:id="rId6" imgW="3730206" imgH="295312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9C4592C-7F97-497D-968D-C50F4F74DB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327270" y="1281281"/>
                        <a:ext cx="2238124" cy="177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3D90850-60E2-4FB1-BB10-815776FDFE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2428306"/>
              </p:ext>
            </p:extLst>
          </p:nvPr>
        </p:nvGraphicFramePr>
        <p:xfrm>
          <a:off x="7182805" y="1281280"/>
          <a:ext cx="2194282" cy="177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657136" imgH="2953125" progId="Prism9.Document">
                  <p:embed/>
                </p:oleObj>
              </mc:Choice>
              <mc:Fallback>
                <p:oleObj name="Prism 9" r:id="rId8" imgW="3657136" imgH="295312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3D90850-60E2-4FB1-BB10-815776FDFE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182805" y="1281280"/>
                        <a:ext cx="2194282" cy="177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4BC5C18C-0EAF-420D-BB2D-FBEFD734CF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8765046"/>
              </p:ext>
            </p:extLst>
          </p:nvPr>
        </p:nvGraphicFramePr>
        <p:xfrm>
          <a:off x="5015733" y="1268484"/>
          <a:ext cx="2244603" cy="1771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741005" imgH="2953125" progId="Prism9.Document">
                  <p:embed/>
                </p:oleObj>
              </mc:Choice>
              <mc:Fallback>
                <p:oleObj name="Prism 9" r:id="rId10" imgW="3741005" imgH="295312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4BC5C18C-0EAF-420D-BB2D-FBEFD734CF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015733" y="1268484"/>
                        <a:ext cx="2244603" cy="1771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EFB644A-6639-4BBC-AB3F-99AB77BA9F94}"/>
              </a:ext>
            </a:extLst>
          </p:cNvPr>
          <p:cNvSpPr txBox="1"/>
          <p:nvPr/>
        </p:nvSpPr>
        <p:spPr>
          <a:xfrm>
            <a:off x="125790" y="4141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60E1B59-E084-EBC2-1A84-C0C07367D641}"/>
              </a:ext>
            </a:extLst>
          </p:cNvPr>
          <p:cNvSpPr txBox="1"/>
          <p:nvPr/>
        </p:nvSpPr>
        <p:spPr>
          <a:xfrm>
            <a:off x="1163603" y="5924551"/>
            <a:ext cx="100250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7.</a:t>
            </a:r>
            <a:r>
              <a:rPr lang="en-US" sz="1200" dirty="0"/>
              <a:t> Effect of YIV-906 on TCR downstream protein phosphorylation of SHP1 and/or SHP2 KO cells. Effect of YIV-906 on LCK (</a:t>
            </a:r>
            <a:r>
              <a:rPr lang="en-US" sz="1200" b="1" dirty="0"/>
              <a:t>A</a:t>
            </a:r>
            <a:r>
              <a:rPr lang="en-US" sz="1200" dirty="0"/>
              <a:t>), Zap70 (</a:t>
            </a:r>
            <a:r>
              <a:rPr lang="en-US" sz="1200" b="1" dirty="0"/>
              <a:t>B</a:t>
            </a:r>
            <a:r>
              <a:rPr lang="en-US" sz="1200" dirty="0"/>
              <a:t>), LAT (</a:t>
            </a:r>
            <a:r>
              <a:rPr lang="en-US" sz="1200" b="1" dirty="0"/>
              <a:t>C</a:t>
            </a:r>
            <a:r>
              <a:rPr lang="en-US" sz="1200" dirty="0"/>
              <a:t>), Fyn (</a:t>
            </a:r>
            <a:r>
              <a:rPr lang="en-US" sz="1200" b="1" dirty="0"/>
              <a:t>D</a:t>
            </a:r>
            <a:r>
              <a:rPr lang="en-US" sz="1200" dirty="0"/>
              <a:t>) and PYK (</a:t>
            </a:r>
            <a:r>
              <a:rPr lang="en-US" sz="1200" b="1" dirty="0"/>
              <a:t>F</a:t>
            </a:r>
            <a:r>
              <a:rPr lang="en-US" sz="1200" dirty="0"/>
              <a:t>) phosphorylation of Jurkat, SHP1-KO, SHP2-KO and SHP1/2 KO cells. (</a:t>
            </a:r>
            <a:r>
              <a:rPr lang="en-US" sz="1200" b="1" dirty="0"/>
              <a:t>G</a:t>
            </a:r>
            <a:r>
              <a:rPr lang="en-US" sz="1200" dirty="0"/>
              <a:t>) Summary of YIV-906 on TCR downstream protein phosphorylation of SHP1 and/or SHP2 KO Jurkat cells. Details of experimental procedures are given in Materials and Method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BD5A201-F567-F7DD-66A6-4DFC58480454}"/>
              </a:ext>
            </a:extLst>
          </p:cNvPr>
          <p:cNvSpPr txBox="1"/>
          <p:nvPr/>
        </p:nvSpPr>
        <p:spPr>
          <a:xfrm>
            <a:off x="890588" y="1052302"/>
            <a:ext cx="8892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                            B                                       C                                      D                                      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A522C4-AC65-22BA-4A67-A78EDF779BA6}"/>
              </a:ext>
            </a:extLst>
          </p:cNvPr>
          <p:cNvSpPr txBox="1"/>
          <p:nvPr/>
        </p:nvSpPr>
        <p:spPr>
          <a:xfrm>
            <a:off x="3763954" y="3198167"/>
            <a:ext cx="437992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Effect of YIV-906 on  TCR down stream </a:t>
            </a:r>
          </a:p>
          <a:p>
            <a:pPr algn="ctr"/>
            <a:r>
              <a:rPr lang="en-US" sz="1200" b="1" dirty="0"/>
              <a:t>protein phosphorylation of SHP1 and/or SHP2 KO  Jurkat cell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523332-C611-DA28-699E-7D01DA8EE554}"/>
              </a:ext>
            </a:extLst>
          </p:cNvPr>
          <p:cNvSpPr txBox="1"/>
          <p:nvPr/>
        </p:nvSpPr>
        <p:spPr>
          <a:xfrm>
            <a:off x="3402669" y="334803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852A12-1E97-E266-96DE-AD56BEAC5FEB}"/>
              </a:ext>
            </a:extLst>
          </p:cNvPr>
          <p:cNvSpPr txBox="1"/>
          <p:nvPr/>
        </p:nvSpPr>
        <p:spPr>
          <a:xfrm>
            <a:off x="3702463" y="5358683"/>
            <a:ext cx="47321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ym typeface="Symbol" panose="05050102010706020507" pitchFamily="18" charset="2"/>
              </a:rPr>
              <a:t>where =increase phosphorylation,  =decrease phosphorylation,  </a:t>
            </a:r>
          </a:p>
          <a:p>
            <a:r>
              <a:rPr lang="en-US" sz="1200" dirty="0">
                <a:sym typeface="Symbol" panose="05050102010706020507" pitchFamily="18" charset="2"/>
              </a:rPr>
              <a:t>“=“ = no change, </a:t>
            </a:r>
            <a:endParaRPr lang="en-US" sz="1200" dirty="0"/>
          </a:p>
        </p:txBody>
      </p:sp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FF1ACAF7-9A94-9B47-0060-1E7021FE20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5793590"/>
              </p:ext>
            </p:extLst>
          </p:nvPr>
        </p:nvGraphicFramePr>
        <p:xfrm>
          <a:off x="3402669" y="3643636"/>
          <a:ext cx="4663440" cy="1779005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1005840">
                  <a:extLst>
                    <a:ext uri="{9D8B030D-6E8A-4147-A177-3AD203B41FA5}">
                      <a16:colId xmlns:a16="http://schemas.microsoft.com/office/drawing/2014/main" val="11130293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708186304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01018375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706632303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747136320"/>
                    </a:ext>
                  </a:extLst>
                </a:gridCol>
              </a:tblGrid>
              <a:tr h="439089"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W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SHP1-K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SHP2-K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SHP1/2</a:t>
                      </a:r>
                    </a:p>
                    <a:p>
                      <a:pPr algn="ctr"/>
                      <a:r>
                        <a:rPr lang="en-US" sz="1100" b="1" dirty="0"/>
                        <a:t>KO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1037150"/>
                  </a:ext>
                </a:extLst>
              </a:tr>
              <a:tr h="270209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P-LCK-Y3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ym typeface="Symbol" panose="05050102010706020507" pitchFamily="18" charset="2"/>
                        </a:rPr>
                        <a:t>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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1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8548985"/>
                  </a:ext>
                </a:extLst>
              </a:tr>
              <a:tr h="270209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P-LAT-Y1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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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</a:t>
                      </a:r>
                      <a:endParaRPr lang="en-US" sz="11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16951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P-PYK2_Y4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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ym typeface="Symbol" panose="05050102010706020507" pitchFamily="18" charset="2"/>
                        </a:rPr>
                        <a:t>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sym typeface="Symbol" panose="05050102010706020507" pitchFamily="18" charset="2"/>
                        </a:rPr>
                        <a:t>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  <a:sym typeface="Symbol" panose="05050102010706020507" pitchFamily="18" charset="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sym typeface="Symbol" panose="05050102010706020507" pitchFamily="18" charset="2"/>
                        </a:rPr>
                        <a:t>=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  <a:sym typeface="Symbol" panose="05050102010706020507" pitchFamily="18" charset="2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7839309"/>
                  </a:ext>
                </a:extLst>
              </a:tr>
              <a:tr h="270209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P-Zap70-Y3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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=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=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=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6077832"/>
                  </a:ext>
                </a:extLst>
              </a:tr>
              <a:tr h="270209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P-Fyn-Y4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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=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sym typeface="Symbol" panose="05050102010706020507" pitchFamily="18" charset="2"/>
                        </a:rPr>
                        <a:t>=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  <a:sym typeface="Symbol" panose="05050102010706020507" pitchFamily="18" charset="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ym typeface="Symbol" panose="05050102010706020507" pitchFamily="18" charset="2"/>
                        </a:rPr>
                        <a:t></a:t>
                      </a:r>
                      <a:endParaRPr kumimoji="0" lang="en-US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  <a:sym typeface="Symbol" panose="05050102010706020507" pitchFamily="18" charset="2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84905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999129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7991E32-B716-1041-0010-F64D45912A93}"/>
              </a:ext>
            </a:extLst>
          </p:cNvPr>
          <p:cNvSpPr txBox="1"/>
          <p:nvPr/>
        </p:nvSpPr>
        <p:spPr>
          <a:xfrm>
            <a:off x="2781905" y="1011162"/>
            <a:ext cx="2981907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                                       B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C                                                D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0AA8A3B-2333-AB90-E376-C377CDFAFC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3101944"/>
              </p:ext>
            </p:extLst>
          </p:nvPr>
        </p:nvGraphicFramePr>
        <p:xfrm>
          <a:off x="5372507" y="1083176"/>
          <a:ext cx="4113431" cy="19541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328356" imgH="3006399" progId="Prism9.Document">
                  <p:embed/>
                </p:oleObj>
              </mc:Choice>
              <mc:Fallback>
                <p:oleObj name="Prism 9" r:id="rId2" imgW="6328356" imgH="300639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0AA8A3B-2333-AB90-E376-C377CDFAFC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72507" y="1083176"/>
                        <a:ext cx="4113431" cy="19541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C43DB96-D068-7265-6639-14ABFE3404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5570530"/>
              </p:ext>
            </p:extLst>
          </p:nvPr>
        </p:nvGraphicFramePr>
        <p:xfrm>
          <a:off x="5373966" y="3048465"/>
          <a:ext cx="4113431" cy="19541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6328356" imgH="3006399" progId="Prism9.Document">
                  <p:embed/>
                </p:oleObj>
              </mc:Choice>
              <mc:Fallback>
                <p:oleObj name="Prism 9" r:id="rId4" imgW="6328356" imgH="3006399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C43DB96-D068-7265-6639-14ABFE3404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73966" y="3048465"/>
                        <a:ext cx="4113431" cy="19541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CD2D473-BB47-071C-8F53-3C00E99467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389440"/>
              </p:ext>
            </p:extLst>
          </p:nvPr>
        </p:nvGraphicFramePr>
        <p:xfrm>
          <a:off x="2852119" y="1092727"/>
          <a:ext cx="2332684" cy="19424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88744" imgH="2988401" progId="Prism9.Document">
                  <p:embed/>
                </p:oleObj>
              </mc:Choice>
              <mc:Fallback>
                <p:oleObj name="Prism 9" r:id="rId6" imgW="3588744" imgH="2988401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CD2D473-BB47-071C-8F53-3C00E99467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52119" y="1092727"/>
                        <a:ext cx="2332684" cy="19424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AAD9655-E3F4-51DB-37CA-007A48B4A6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689454"/>
              </p:ext>
            </p:extLst>
          </p:nvPr>
        </p:nvGraphicFramePr>
        <p:xfrm>
          <a:off x="2857237" y="3058141"/>
          <a:ext cx="2332684" cy="19424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588744" imgH="2988401" progId="Prism9.Document">
                  <p:embed/>
                </p:oleObj>
              </mc:Choice>
              <mc:Fallback>
                <p:oleObj name="Prism 9" r:id="rId8" imgW="3588744" imgH="2988401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BAAD9655-E3F4-51DB-37CA-007A48B4A6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57237" y="3058141"/>
                        <a:ext cx="2332684" cy="19424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EFB19E9-B314-B1A6-4692-B2529CCD6911}"/>
              </a:ext>
            </a:extLst>
          </p:cNvPr>
          <p:cNvSpPr txBox="1"/>
          <p:nvPr/>
        </p:nvSpPr>
        <p:spPr>
          <a:xfrm>
            <a:off x="-45556" y="-819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8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A8286C-7533-2BCB-B017-81FD53E8A4E8}"/>
              </a:ext>
            </a:extLst>
          </p:cNvPr>
          <p:cNvSpPr txBox="1"/>
          <p:nvPr/>
        </p:nvSpPr>
        <p:spPr>
          <a:xfrm>
            <a:off x="2543230" y="5002746"/>
            <a:ext cx="733794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S8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Effects of YIV-906, S, and S compounds with and without anti-PD1 on NFAT mediated transcriptional activity of Jurkat cells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-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Effects of YIV-906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,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, and S compounds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on NFAT mediated transcriptional activity of Jurkat-PD1 cells incubated with Raji wt cells and SEE 10ng/ml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-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Effects of YIV-906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,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and S compounds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on NFAT mediated transcriptional activity of Jurkat-PD1 cells incubated with Raji-PD-L1 cells, SEE 10ng/ml and anti-PD1 18ug/ml. Cells and drugs were incubated for 24h before luciferase activity was measured. Details of experimental procedures are given in Materials and Method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23762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767500F-CF4F-850B-3696-261590C69D57}"/>
              </a:ext>
            </a:extLst>
          </p:cNvPr>
          <p:cNvGrpSpPr/>
          <p:nvPr/>
        </p:nvGrpSpPr>
        <p:grpSpPr>
          <a:xfrm>
            <a:off x="2922550" y="113748"/>
            <a:ext cx="7403474" cy="6749015"/>
            <a:chOff x="2546888" y="0"/>
            <a:chExt cx="7403474" cy="674901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0603F63-3833-E092-3201-1BB7CFDC243A}"/>
                </a:ext>
              </a:extLst>
            </p:cNvPr>
            <p:cNvSpPr txBox="1"/>
            <p:nvPr/>
          </p:nvSpPr>
          <p:spPr>
            <a:xfrm>
              <a:off x="2546888" y="0"/>
              <a:ext cx="3057247" cy="4801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                                                 B</a:t>
              </a:r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r>
                <a:rPr lang="en-US" b="1" dirty="0"/>
                <a:t>                                                    C</a:t>
              </a:r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endParaRPr lang="en-US" b="1" dirty="0"/>
            </a:p>
            <a:p>
              <a:r>
                <a:rPr lang="en-US" b="1" dirty="0"/>
                <a:t>                                                   D</a:t>
              </a:r>
            </a:p>
          </p:txBody>
        </p:sp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5737686C-DFA0-441F-80B3-52714BCA784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224759" y="130199"/>
            <a:ext cx="4711982" cy="22890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6282642" imgH="3052115" progId="Prism9.Document">
                    <p:embed/>
                  </p:oleObj>
                </mc:Choice>
                <mc:Fallback>
                  <p:oleObj name="Prism 9" r:id="rId2" imgW="6282642" imgH="3052115" progId="Prism9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5737686C-DFA0-441F-80B3-52714BCA78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224759" y="130199"/>
                          <a:ext cx="4711982" cy="22890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>
              <a:extLst>
                <a:ext uri="{FF2B5EF4-FFF2-40B4-BE49-F238E27FC236}">
                  <a16:creationId xmlns:a16="http://schemas.microsoft.com/office/drawing/2014/main" id="{6978C76F-79B9-457F-A53B-D1458C3DD4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0558698"/>
                </p:ext>
              </p:extLst>
            </p:nvPr>
          </p:nvGraphicFramePr>
          <p:xfrm>
            <a:off x="5204095" y="2309036"/>
            <a:ext cx="4746267" cy="22890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6328356" imgH="3052115" progId="Prism9.Document">
                    <p:embed/>
                  </p:oleObj>
                </mc:Choice>
                <mc:Fallback>
                  <p:oleObj name="Prism 9" r:id="rId4" imgW="6328356" imgH="3052115" progId="Prism9.Document">
                    <p:embed/>
                    <p:pic>
                      <p:nvPicPr>
                        <p:cNvPr id="33" name="Object 32">
                          <a:extLst>
                            <a:ext uri="{FF2B5EF4-FFF2-40B4-BE49-F238E27FC236}">
                              <a16:creationId xmlns:a16="http://schemas.microsoft.com/office/drawing/2014/main" id="{6978C76F-79B9-457F-A53B-D1458C3DD4A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204095" y="2309036"/>
                          <a:ext cx="4746267" cy="22890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D40D6C55-DF32-4348-995C-29607C7B722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198316" y="4479367"/>
            <a:ext cx="4746267" cy="226964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6328356" imgH="3026197" progId="Prism9.Document">
                    <p:embed/>
                  </p:oleObj>
                </mc:Choice>
                <mc:Fallback>
                  <p:oleObj name="Prism 9" r:id="rId6" imgW="6328356" imgH="3026197" progId="Prism9.Document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D40D6C55-DF32-4348-995C-29607C7B722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198316" y="4479367"/>
                          <a:ext cx="4746267" cy="226964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20772E47-178E-2574-126D-B523D3D476D8}"/>
              </a:ext>
            </a:extLst>
          </p:cNvPr>
          <p:cNvSpPr txBox="1"/>
          <p:nvPr/>
        </p:nvSpPr>
        <p:spPr>
          <a:xfrm>
            <a:off x="-45556" y="-819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9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E0581F-FF9C-8FFC-01FC-56DE5082578B}"/>
              </a:ext>
            </a:extLst>
          </p:cNvPr>
          <p:cNvSpPr txBox="1"/>
          <p:nvPr/>
        </p:nvSpPr>
        <p:spPr>
          <a:xfrm>
            <a:off x="491551" y="2998636"/>
            <a:ext cx="5029199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9</a:t>
            </a:r>
            <a:r>
              <a:rPr lang="en-US" sz="1200" dirty="0"/>
              <a:t>. Effects of YIV-906, </a:t>
            </a:r>
            <a:r>
              <a:rPr lang="en-US" sz="1200" b="1" dirty="0"/>
              <a:t>S</a:t>
            </a:r>
            <a:r>
              <a:rPr lang="en-US" sz="1200" dirty="0"/>
              <a:t> and </a:t>
            </a:r>
            <a:r>
              <a:rPr lang="en-US" sz="1200" b="1" dirty="0"/>
              <a:t>S</a:t>
            </a:r>
            <a:r>
              <a:rPr lang="en-US" sz="1200" dirty="0"/>
              <a:t> compounds on NFAT mediated transcriptional activity of Jurkat cells triggered by the interaction of chimeric antigen receptor (CAR-CD19-CD3z) on Jurkat cells with CD19 on Raji cells. Effects of YIV-906 (</a:t>
            </a:r>
            <a:r>
              <a:rPr lang="en-US" sz="1200" b="1" dirty="0"/>
              <a:t>A</a:t>
            </a:r>
            <a:r>
              <a:rPr lang="en-US" sz="1200" dirty="0"/>
              <a:t>), </a:t>
            </a:r>
            <a:r>
              <a:rPr lang="en-US" sz="1200" b="1" dirty="0"/>
              <a:t>S</a:t>
            </a:r>
            <a:r>
              <a:rPr lang="en-US" sz="1200" dirty="0"/>
              <a:t> (</a:t>
            </a:r>
            <a:r>
              <a:rPr lang="en-US" sz="1200" b="1" dirty="0"/>
              <a:t>A</a:t>
            </a:r>
            <a:r>
              <a:rPr lang="en-US" sz="1200" dirty="0"/>
              <a:t>), and S compounds (</a:t>
            </a:r>
            <a:r>
              <a:rPr lang="en-US" sz="1200" b="1" dirty="0"/>
              <a:t>B</a:t>
            </a:r>
            <a:r>
              <a:rPr lang="en-US" sz="1200" dirty="0"/>
              <a:t>) on basal level of NFAT-mediated transcriptional activity of Jurkat-PD1 cells carrying chimeric antigen receptor (CAR-CD19-CD3z) are shown. (</a:t>
            </a:r>
            <a:r>
              <a:rPr lang="en-US" sz="1200" b="1" dirty="0"/>
              <a:t>C</a:t>
            </a:r>
            <a:r>
              <a:rPr lang="en-US" sz="1200" dirty="0"/>
              <a:t>) Effects of S compounds on NFAT mediated transcriptional activity of Jurkat-PD1 cells carrying chimeric antigen receptor (CAR-CD19-CD3z) and incubated with Raji cells.   (</a:t>
            </a:r>
            <a:r>
              <a:rPr lang="en-US" sz="1200" b="1" dirty="0"/>
              <a:t>D</a:t>
            </a:r>
            <a:r>
              <a:rPr lang="en-US" sz="1200" dirty="0"/>
              <a:t>) Effect of </a:t>
            </a:r>
            <a:r>
              <a:rPr lang="en-US" sz="1200" b="1" dirty="0"/>
              <a:t>S</a:t>
            </a:r>
            <a:r>
              <a:rPr lang="en-US" sz="1200" dirty="0"/>
              <a:t> compounds on NFAT-mediated transcriptional activity of Jurkat-PD1 cells carrying chimeric antigen receptor (CAR-CD19-CD3z) and incubated with Raji-PD-L1 cells.  YIV-906, S and S compounds were added to Jurkat-PD1-CAR-CD19 cells, which were stably transfected with NFAT luciferase reporter, together with wild type Raji cells or Raji-PD-L1 cells for 24 h before luciferase activity was measured. Details of experimental procedures are given in Materials and Methods.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3785393-29EE-EDB1-047A-E0563C736E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7894344"/>
              </p:ext>
            </p:extLst>
          </p:nvPr>
        </p:nvGraphicFramePr>
        <p:xfrm>
          <a:off x="2864862" y="267764"/>
          <a:ext cx="2655888" cy="220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539790" imgH="2942686" progId="Prism9.Document">
                  <p:embed/>
                </p:oleObj>
              </mc:Choice>
              <mc:Fallback>
                <p:oleObj name="Prism 9" r:id="rId8" imgW="3539790" imgH="2942686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74E1ECF-93CA-48FD-B350-B6DF5AEF94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64862" y="267764"/>
                        <a:ext cx="2655888" cy="220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10375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1</TotalTime>
  <Words>1546</Words>
  <Application>Microsoft Office PowerPoint</Application>
  <PresentationFormat>Widescreen</PresentationFormat>
  <Paragraphs>186</Paragraphs>
  <Slides>1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Symbol</vt:lpstr>
      <vt:lpstr>Office Theme</vt:lpstr>
      <vt:lpstr>Prism 9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g LAM</dc:creator>
  <cp:lastModifiedBy>Wing LAM</cp:lastModifiedBy>
  <cp:revision>102</cp:revision>
  <cp:lastPrinted>2022-12-05T21:15:18Z</cp:lastPrinted>
  <dcterms:created xsi:type="dcterms:W3CDTF">2022-08-03T20:08:04Z</dcterms:created>
  <dcterms:modified xsi:type="dcterms:W3CDTF">2022-12-08T14:06:50Z</dcterms:modified>
</cp:coreProperties>
</file>